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3.xml" ContentType="application/vnd.openxmlformats-officedocument.drawingml.chartshapes+xml"/>
  <Override PartName="/ppt/charts/chart5.xml" ContentType="application/vnd.openxmlformats-officedocument.drawingml.chart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128" y="2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870-54\Projets%20bis\Projets%20AMM\Articles\Article%20translocon%204.6.13\Article%20translocon%2018.7.14\Calcium\%20Figures%20Calcium%2018-07-2014\Graph_aigu_il&#244;t_SD.xlsx" TargetMode="External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870-54\Projets%20bis\Projets%20AMM\Articles\Article%20translocon%204.6.13\Article%20translocon%2018.7.14\Calcium\%20Figures%20Calcium%2018-07-2014\Graph_aigu_il&#244;t_SD.xlsx" TargetMode="External"/><Relationship Id="rId2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870-54\Projets%20bis\Projets%20AMM\Articles\Article%20translocon%204.6.13\Article%20translocon%2018.7.14\Calcium\%20Figures%20Calcium%2018-07-2014\Calcium%20aigu%20bilan_MIN6B1_S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U870-54\Projets%20bis\Projets%20AMM\Articles\Article%20translocon%204.6.13\Article%20translocon%2018.7.14\Calcium\%20Figures%20Calcium%2018-07-2014\Calcium%20aigu%20bilan_MIN6B1_SD.xlsx" TargetMode="External"/><Relationship Id="rId2" Type="http://schemas.openxmlformats.org/officeDocument/2006/relationships/chartUserShapes" Target="../drawings/drawing3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U870-54\Projets%20bis\Projets%20AMM\Articles\Article%20translocon%204.6.13\Article%20translocon%2018.7.14\Calcium\%20Figures%20Calcium%2018-07-2014\Calcium%20aigu%20bilan_MIN6B1_SD.xlsx" TargetMode="External"/><Relationship Id="rId2" Type="http://schemas.openxmlformats.org/officeDocument/2006/relationships/chartUserShapes" Target="../drawings/drawing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2835699135259"/>
          <c:y val="0.0312604016603188"/>
          <c:w val="0.718593571545113"/>
          <c:h val="0.712619549929677"/>
        </c:manualLayout>
      </c:layout>
      <c:lineChart>
        <c:grouping val="standard"/>
        <c:varyColors val="0"/>
        <c:ser>
          <c:idx val="0"/>
          <c:order val="0"/>
          <c:tx>
            <c:v>without AO pretreatment</c:v>
          </c:tx>
          <c:spPr>
            <a:ln>
              <a:solidFill>
                <a:schemeClr val="bg1"/>
              </a:solidFill>
            </a:ln>
          </c:spPr>
          <c:marker>
            <c:symbol val="none"/>
          </c:marker>
          <c:trendline>
            <c:spPr>
              <a:ln w="12700">
                <a:solidFill>
                  <a:schemeClr val="tx1"/>
                </a:solidFill>
              </a:ln>
            </c:spPr>
            <c:trendlineType val="movingAvg"/>
            <c:period val="4"/>
            <c:dispRSqr val="0"/>
            <c:dispEq val="0"/>
          </c:trendline>
          <c:cat>
            <c:numRef>
              <c:f>'Feuil1 (2)'!$A$1:$A$101</c:f>
              <c:numCache>
                <c:formatCode>General</c:formatCode>
                <c:ptCount val="101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15.0</c:v>
                </c:pt>
                <c:pt idx="4">
                  <c:v>20.0</c:v>
                </c:pt>
                <c:pt idx="5">
                  <c:v>25.0</c:v>
                </c:pt>
                <c:pt idx="6">
                  <c:v>30.0</c:v>
                </c:pt>
                <c:pt idx="7">
                  <c:v>35.0</c:v>
                </c:pt>
                <c:pt idx="8">
                  <c:v>40.0</c:v>
                </c:pt>
                <c:pt idx="9">
                  <c:v>45.0</c:v>
                </c:pt>
                <c:pt idx="10">
                  <c:v>50.0</c:v>
                </c:pt>
                <c:pt idx="11">
                  <c:v>55.0</c:v>
                </c:pt>
                <c:pt idx="12">
                  <c:v>60.0</c:v>
                </c:pt>
                <c:pt idx="13">
                  <c:v>65.0</c:v>
                </c:pt>
                <c:pt idx="14">
                  <c:v>70.0</c:v>
                </c:pt>
                <c:pt idx="15">
                  <c:v>75.0</c:v>
                </c:pt>
                <c:pt idx="16">
                  <c:v>80.0</c:v>
                </c:pt>
                <c:pt idx="17">
                  <c:v>85.0</c:v>
                </c:pt>
                <c:pt idx="18">
                  <c:v>90.0</c:v>
                </c:pt>
                <c:pt idx="19">
                  <c:v>95.0</c:v>
                </c:pt>
                <c:pt idx="20">
                  <c:v>100.0</c:v>
                </c:pt>
                <c:pt idx="21">
                  <c:v>105.0</c:v>
                </c:pt>
                <c:pt idx="22">
                  <c:v>110.0</c:v>
                </c:pt>
                <c:pt idx="23">
                  <c:v>115.0</c:v>
                </c:pt>
                <c:pt idx="24">
                  <c:v>120.0</c:v>
                </c:pt>
                <c:pt idx="25">
                  <c:v>125.0</c:v>
                </c:pt>
                <c:pt idx="26">
                  <c:v>130.0</c:v>
                </c:pt>
                <c:pt idx="27">
                  <c:v>135.0</c:v>
                </c:pt>
                <c:pt idx="28">
                  <c:v>140.0</c:v>
                </c:pt>
                <c:pt idx="29">
                  <c:v>145.0</c:v>
                </c:pt>
                <c:pt idx="30">
                  <c:v>150.0</c:v>
                </c:pt>
                <c:pt idx="31">
                  <c:v>155.0</c:v>
                </c:pt>
                <c:pt idx="32">
                  <c:v>160.0</c:v>
                </c:pt>
                <c:pt idx="33">
                  <c:v>165.0</c:v>
                </c:pt>
                <c:pt idx="34">
                  <c:v>170.0</c:v>
                </c:pt>
                <c:pt idx="35">
                  <c:v>175.0</c:v>
                </c:pt>
                <c:pt idx="36">
                  <c:v>180.0</c:v>
                </c:pt>
                <c:pt idx="37">
                  <c:v>185.0</c:v>
                </c:pt>
                <c:pt idx="38">
                  <c:v>190.0</c:v>
                </c:pt>
                <c:pt idx="39">
                  <c:v>195.0</c:v>
                </c:pt>
                <c:pt idx="40">
                  <c:v>200.0</c:v>
                </c:pt>
                <c:pt idx="41">
                  <c:v>205.0</c:v>
                </c:pt>
                <c:pt idx="42">
                  <c:v>210.0</c:v>
                </c:pt>
                <c:pt idx="43">
                  <c:v>215.0</c:v>
                </c:pt>
                <c:pt idx="44">
                  <c:v>220.0</c:v>
                </c:pt>
                <c:pt idx="45">
                  <c:v>225.0</c:v>
                </c:pt>
                <c:pt idx="46">
                  <c:v>230.0</c:v>
                </c:pt>
                <c:pt idx="47">
                  <c:v>235.0</c:v>
                </c:pt>
                <c:pt idx="48">
                  <c:v>240.0</c:v>
                </c:pt>
                <c:pt idx="49">
                  <c:v>245.0</c:v>
                </c:pt>
                <c:pt idx="50">
                  <c:v>250.0</c:v>
                </c:pt>
                <c:pt idx="51">
                  <c:v>255.0</c:v>
                </c:pt>
                <c:pt idx="52">
                  <c:v>260.0</c:v>
                </c:pt>
                <c:pt idx="53">
                  <c:v>265.0</c:v>
                </c:pt>
                <c:pt idx="54">
                  <c:v>270.0</c:v>
                </c:pt>
                <c:pt idx="55">
                  <c:v>275.0</c:v>
                </c:pt>
                <c:pt idx="56">
                  <c:v>280.0</c:v>
                </c:pt>
                <c:pt idx="57">
                  <c:v>285.0</c:v>
                </c:pt>
                <c:pt idx="58">
                  <c:v>290.0</c:v>
                </c:pt>
                <c:pt idx="59">
                  <c:v>295.0</c:v>
                </c:pt>
                <c:pt idx="60">
                  <c:v>300.0</c:v>
                </c:pt>
                <c:pt idx="61">
                  <c:v>305.0</c:v>
                </c:pt>
                <c:pt idx="62">
                  <c:v>310.0</c:v>
                </c:pt>
                <c:pt idx="63">
                  <c:v>315.0</c:v>
                </c:pt>
                <c:pt idx="64">
                  <c:v>320.0</c:v>
                </c:pt>
                <c:pt idx="65">
                  <c:v>325.0</c:v>
                </c:pt>
                <c:pt idx="66">
                  <c:v>330.0</c:v>
                </c:pt>
                <c:pt idx="67">
                  <c:v>335.0</c:v>
                </c:pt>
                <c:pt idx="68">
                  <c:v>340.0</c:v>
                </c:pt>
                <c:pt idx="69">
                  <c:v>345.0</c:v>
                </c:pt>
                <c:pt idx="70">
                  <c:v>350.0</c:v>
                </c:pt>
                <c:pt idx="71">
                  <c:v>355.0</c:v>
                </c:pt>
                <c:pt idx="72">
                  <c:v>360.0</c:v>
                </c:pt>
                <c:pt idx="73">
                  <c:v>365.0</c:v>
                </c:pt>
                <c:pt idx="74">
                  <c:v>370.0</c:v>
                </c:pt>
                <c:pt idx="75">
                  <c:v>375.0</c:v>
                </c:pt>
                <c:pt idx="76">
                  <c:v>380.0</c:v>
                </c:pt>
                <c:pt idx="77">
                  <c:v>385.0</c:v>
                </c:pt>
                <c:pt idx="78">
                  <c:v>390.0</c:v>
                </c:pt>
                <c:pt idx="79">
                  <c:v>395.0</c:v>
                </c:pt>
                <c:pt idx="80">
                  <c:v>400.0</c:v>
                </c:pt>
                <c:pt idx="81">
                  <c:v>405.0</c:v>
                </c:pt>
                <c:pt idx="82">
                  <c:v>410.0</c:v>
                </c:pt>
                <c:pt idx="83">
                  <c:v>415.0</c:v>
                </c:pt>
                <c:pt idx="84">
                  <c:v>420.0</c:v>
                </c:pt>
                <c:pt idx="85">
                  <c:v>425.0</c:v>
                </c:pt>
                <c:pt idx="86">
                  <c:v>430.0</c:v>
                </c:pt>
                <c:pt idx="87">
                  <c:v>435.0</c:v>
                </c:pt>
                <c:pt idx="88">
                  <c:v>440.0</c:v>
                </c:pt>
                <c:pt idx="89">
                  <c:v>445.0</c:v>
                </c:pt>
                <c:pt idx="90">
                  <c:v>450.0</c:v>
                </c:pt>
                <c:pt idx="91">
                  <c:v>455.0</c:v>
                </c:pt>
                <c:pt idx="92">
                  <c:v>460.0</c:v>
                </c:pt>
                <c:pt idx="93">
                  <c:v>465.0</c:v>
                </c:pt>
                <c:pt idx="94">
                  <c:v>470.0</c:v>
                </c:pt>
                <c:pt idx="95">
                  <c:v>475.0</c:v>
                </c:pt>
                <c:pt idx="96">
                  <c:v>480.0</c:v>
                </c:pt>
                <c:pt idx="97">
                  <c:v>485.0</c:v>
                </c:pt>
                <c:pt idx="98">
                  <c:v>490.0</c:v>
                </c:pt>
                <c:pt idx="99">
                  <c:v>495.0</c:v>
                </c:pt>
                <c:pt idx="100">
                  <c:v>500.0</c:v>
                </c:pt>
              </c:numCache>
            </c:numRef>
          </c:cat>
          <c:val>
            <c:numRef>
              <c:f>'Feuil1 (2)'!$B$1:$B$100</c:f>
              <c:numCache>
                <c:formatCode>General</c:formatCode>
                <c:ptCount val="100"/>
                <c:pt idx="0">
                  <c:v>0.3764454</c:v>
                </c:pt>
                <c:pt idx="1">
                  <c:v>0.3764454</c:v>
                </c:pt>
                <c:pt idx="2">
                  <c:v>0.3764454</c:v>
                </c:pt>
                <c:pt idx="3">
                  <c:v>0.3764454</c:v>
                </c:pt>
                <c:pt idx="4">
                  <c:v>0.3764454</c:v>
                </c:pt>
                <c:pt idx="5">
                  <c:v>0.3764454</c:v>
                </c:pt>
                <c:pt idx="6">
                  <c:v>0.3764454</c:v>
                </c:pt>
                <c:pt idx="7">
                  <c:v>0.3764454</c:v>
                </c:pt>
                <c:pt idx="8">
                  <c:v>0.3764454</c:v>
                </c:pt>
                <c:pt idx="9">
                  <c:v>0.3764454</c:v>
                </c:pt>
                <c:pt idx="10">
                  <c:v>0.38899358</c:v>
                </c:pt>
                <c:pt idx="11">
                  <c:v>0.38899358</c:v>
                </c:pt>
                <c:pt idx="12">
                  <c:v>0.38899358</c:v>
                </c:pt>
                <c:pt idx="13">
                  <c:v>0.3764454</c:v>
                </c:pt>
                <c:pt idx="14">
                  <c:v>0.3764454</c:v>
                </c:pt>
                <c:pt idx="15">
                  <c:v>0.3764454</c:v>
                </c:pt>
                <c:pt idx="16">
                  <c:v>0.3764454</c:v>
                </c:pt>
                <c:pt idx="17">
                  <c:v>0.3764454</c:v>
                </c:pt>
                <c:pt idx="18">
                  <c:v>0.3764454</c:v>
                </c:pt>
                <c:pt idx="19">
                  <c:v>0.3764454</c:v>
                </c:pt>
                <c:pt idx="20">
                  <c:v>0.3764454</c:v>
                </c:pt>
                <c:pt idx="21">
                  <c:v>0.36389722</c:v>
                </c:pt>
                <c:pt idx="22">
                  <c:v>0.3764454</c:v>
                </c:pt>
                <c:pt idx="23">
                  <c:v>0.3764454</c:v>
                </c:pt>
                <c:pt idx="24">
                  <c:v>0.3764454</c:v>
                </c:pt>
                <c:pt idx="25">
                  <c:v>0.38899358</c:v>
                </c:pt>
                <c:pt idx="26">
                  <c:v>0.38899358</c:v>
                </c:pt>
                <c:pt idx="27">
                  <c:v>0.40154176</c:v>
                </c:pt>
                <c:pt idx="28">
                  <c:v>0.41408994</c:v>
                </c:pt>
                <c:pt idx="29">
                  <c:v>0.42663812</c:v>
                </c:pt>
                <c:pt idx="30">
                  <c:v>0.45173448</c:v>
                </c:pt>
                <c:pt idx="31">
                  <c:v>0.46428266</c:v>
                </c:pt>
                <c:pt idx="32">
                  <c:v>0.48937902</c:v>
                </c:pt>
                <c:pt idx="33">
                  <c:v>0.51447538</c:v>
                </c:pt>
                <c:pt idx="34">
                  <c:v>0.53957174</c:v>
                </c:pt>
                <c:pt idx="35">
                  <c:v>0.55211992</c:v>
                </c:pt>
                <c:pt idx="36">
                  <c:v>0.55211992</c:v>
                </c:pt>
                <c:pt idx="37">
                  <c:v>0.5646681</c:v>
                </c:pt>
                <c:pt idx="38">
                  <c:v>0.55211992</c:v>
                </c:pt>
                <c:pt idx="39">
                  <c:v>0.55211992</c:v>
                </c:pt>
                <c:pt idx="40">
                  <c:v>0.55211992</c:v>
                </c:pt>
                <c:pt idx="41">
                  <c:v>0.55211992</c:v>
                </c:pt>
                <c:pt idx="42">
                  <c:v>0.53957174</c:v>
                </c:pt>
                <c:pt idx="43">
                  <c:v>0.53957174</c:v>
                </c:pt>
                <c:pt idx="44">
                  <c:v>0.53957174</c:v>
                </c:pt>
                <c:pt idx="45">
                  <c:v>0.53957174</c:v>
                </c:pt>
                <c:pt idx="46">
                  <c:v>0.53957174</c:v>
                </c:pt>
                <c:pt idx="47">
                  <c:v>0.52702356</c:v>
                </c:pt>
                <c:pt idx="48">
                  <c:v>0.52702356</c:v>
                </c:pt>
                <c:pt idx="49">
                  <c:v>0.53957174</c:v>
                </c:pt>
                <c:pt idx="50">
                  <c:v>0.53957174</c:v>
                </c:pt>
                <c:pt idx="51">
                  <c:v>0.53957174</c:v>
                </c:pt>
                <c:pt idx="52">
                  <c:v>0.53957174</c:v>
                </c:pt>
                <c:pt idx="53">
                  <c:v>0.52702356</c:v>
                </c:pt>
                <c:pt idx="54">
                  <c:v>0.52702356</c:v>
                </c:pt>
                <c:pt idx="55">
                  <c:v>0.52702356</c:v>
                </c:pt>
                <c:pt idx="56">
                  <c:v>0.52702356</c:v>
                </c:pt>
                <c:pt idx="57">
                  <c:v>0.51447538</c:v>
                </c:pt>
                <c:pt idx="58">
                  <c:v>0.51447538</c:v>
                </c:pt>
                <c:pt idx="59">
                  <c:v>0.51447538</c:v>
                </c:pt>
                <c:pt idx="60">
                  <c:v>0.51447538</c:v>
                </c:pt>
                <c:pt idx="61">
                  <c:v>0.5019272</c:v>
                </c:pt>
                <c:pt idx="62">
                  <c:v>0.5019272</c:v>
                </c:pt>
                <c:pt idx="63">
                  <c:v>0.48937902</c:v>
                </c:pt>
                <c:pt idx="64">
                  <c:v>0.48937902</c:v>
                </c:pt>
                <c:pt idx="65">
                  <c:v>0.47683084</c:v>
                </c:pt>
                <c:pt idx="66">
                  <c:v>0.47683084</c:v>
                </c:pt>
                <c:pt idx="67">
                  <c:v>0.47683084</c:v>
                </c:pt>
                <c:pt idx="68">
                  <c:v>0.46428266</c:v>
                </c:pt>
                <c:pt idx="69">
                  <c:v>0.46428266</c:v>
                </c:pt>
                <c:pt idx="70">
                  <c:v>0.45173448</c:v>
                </c:pt>
                <c:pt idx="71">
                  <c:v>0.45173448</c:v>
                </c:pt>
                <c:pt idx="72">
                  <c:v>0.45173448</c:v>
                </c:pt>
                <c:pt idx="73">
                  <c:v>0.4391863</c:v>
                </c:pt>
                <c:pt idx="74">
                  <c:v>0.4391863</c:v>
                </c:pt>
                <c:pt idx="75">
                  <c:v>0.4391863</c:v>
                </c:pt>
                <c:pt idx="76">
                  <c:v>0.4391863</c:v>
                </c:pt>
                <c:pt idx="77">
                  <c:v>0.4391863</c:v>
                </c:pt>
                <c:pt idx="78">
                  <c:v>0.42663812</c:v>
                </c:pt>
                <c:pt idx="79">
                  <c:v>0.42663812</c:v>
                </c:pt>
                <c:pt idx="80">
                  <c:v>0.42663812</c:v>
                </c:pt>
                <c:pt idx="81">
                  <c:v>0.4391863</c:v>
                </c:pt>
                <c:pt idx="82">
                  <c:v>0.42663812</c:v>
                </c:pt>
                <c:pt idx="83">
                  <c:v>0.42663812</c:v>
                </c:pt>
                <c:pt idx="84">
                  <c:v>0.42663812</c:v>
                </c:pt>
                <c:pt idx="85">
                  <c:v>0.42663812</c:v>
                </c:pt>
                <c:pt idx="86">
                  <c:v>0.42663812</c:v>
                </c:pt>
                <c:pt idx="87">
                  <c:v>0.42663812</c:v>
                </c:pt>
                <c:pt idx="88">
                  <c:v>0.41408994</c:v>
                </c:pt>
                <c:pt idx="89">
                  <c:v>0.41408994</c:v>
                </c:pt>
                <c:pt idx="90">
                  <c:v>0.41408994</c:v>
                </c:pt>
                <c:pt idx="91">
                  <c:v>0.41408994</c:v>
                </c:pt>
                <c:pt idx="92">
                  <c:v>0.41408994</c:v>
                </c:pt>
                <c:pt idx="93">
                  <c:v>0.41408994</c:v>
                </c:pt>
                <c:pt idx="94">
                  <c:v>0.41408994</c:v>
                </c:pt>
                <c:pt idx="95">
                  <c:v>0.40154176</c:v>
                </c:pt>
                <c:pt idx="96">
                  <c:v>0.40154176</c:v>
                </c:pt>
                <c:pt idx="97">
                  <c:v>0.40154176</c:v>
                </c:pt>
                <c:pt idx="98">
                  <c:v>0.40154176</c:v>
                </c:pt>
                <c:pt idx="99">
                  <c:v>0.40154176</c:v>
                </c:pt>
              </c:numCache>
            </c:numRef>
          </c:val>
          <c:smooth val="0"/>
        </c:ser>
        <c:ser>
          <c:idx val="1"/>
          <c:order val="1"/>
          <c:tx>
            <c:v>with AO pretreatment</c:v>
          </c:tx>
          <c:spPr>
            <a:ln>
              <a:solidFill>
                <a:schemeClr val="bg1"/>
              </a:solidFill>
            </a:ln>
          </c:spPr>
          <c:marker>
            <c:symbol val="none"/>
          </c:marker>
          <c:trendline>
            <c:spPr>
              <a:ln w="12700">
                <a:solidFill>
                  <a:schemeClr val="bg1">
                    <a:lumMod val="50000"/>
                  </a:schemeClr>
                </a:solidFill>
              </a:ln>
            </c:spPr>
            <c:trendlineType val="movingAvg"/>
            <c:period val="4"/>
            <c:dispRSqr val="0"/>
            <c:dispEq val="0"/>
          </c:trendline>
          <c:cat>
            <c:numRef>
              <c:f>'Feuil1 (2)'!$A$1:$A$101</c:f>
              <c:numCache>
                <c:formatCode>General</c:formatCode>
                <c:ptCount val="101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15.0</c:v>
                </c:pt>
                <c:pt idx="4">
                  <c:v>20.0</c:v>
                </c:pt>
                <c:pt idx="5">
                  <c:v>25.0</c:v>
                </c:pt>
                <c:pt idx="6">
                  <c:v>30.0</c:v>
                </c:pt>
                <c:pt idx="7">
                  <c:v>35.0</c:v>
                </c:pt>
                <c:pt idx="8">
                  <c:v>40.0</c:v>
                </c:pt>
                <c:pt idx="9">
                  <c:v>45.0</c:v>
                </c:pt>
                <c:pt idx="10">
                  <c:v>50.0</c:v>
                </c:pt>
                <c:pt idx="11">
                  <c:v>55.0</c:v>
                </c:pt>
                <c:pt idx="12">
                  <c:v>60.0</c:v>
                </c:pt>
                <c:pt idx="13">
                  <c:v>65.0</c:v>
                </c:pt>
                <c:pt idx="14">
                  <c:v>70.0</c:v>
                </c:pt>
                <c:pt idx="15">
                  <c:v>75.0</c:v>
                </c:pt>
                <c:pt idx="16">
                  <c:v>80.0</c:v>
                </c:pt>
                <c:pt idx="17">
                  <c:v>85.0</c:v>
                </c:pt>
                <c:pt idx="18">
                  <c:v>90.0</c:v>
                </c:pt>
                <c:pt idx="19">
                  <c:v>95.0</c:v>
                </c:pt>
                <c:pt idx="20">
                  <c:v>100.0</c:v>
                </c:pt>
                <c:pt idx="21">
                  <c:v>105.0</c:v>
                </c:pt>
                <c:pt idx="22">
                  <c:v>110.0</c:v>
                </c:pt>
                <c:pt idx="23">
                  <c:v>115.0</c:v>
                </c:pt>
                <c:pt idx="24">
                  <c:v>120.0</c:v>
                </c:pt>
                <c:pt idx="25">
                  <c:v>125.0</c:v>
                </c:pt>
                <c:pt idx="26">
                  <c:v>130.0</c:v>
                </c:pt>
                <c:pt idx="27">
                  <c:v>135.0</c:v>
                </c:pt>
                <c:pt idx="28">
                  <c:v>140.0</c:v>
                </c:pt>
                <c:pt idx="29">
                  <c:v>145.0</c:v>
                </c:pt>
                <c:pt idx="30">
                  <c:v>150.0</c:v>
                </c:pt>
                <c:pt idx="31">
                  <c:v>155.0</c:v>
                </c:pt>
                <c:pt idx="32">
                  <c:v>160.0</c:v>
                </c:pt>
                <c:pt idx="33">
                  <c:v>165.0</c:v>
                </c:pt>
                <c:pt idx="34">
                  <c:v>170.0</c:v>
                </c:pt>
                <c:pt idx="35">
                  <c:v>175.0</c:v>
                </c:pt>
                <c:pt idx="36">
                  <c:v>180.0</c:v>
                </c:pt>
                <c:pt idx="37">
                  <c:v>185.0</c:v>
                </c:pt>
                <c:pt idx="38">
                  <c:v>190.0</c:v>
                </c:pt>
                <c:pt idx="39">
                  <c:v>195.0</c:v>
                </c:pt>
                <c:pt idx="40">
                  <c:v>200.0</c:v>
                </c:pt>
                <c:pt idx="41">
                  <c:v>205.0</c:v>
                </c:pt>
                <c:pt idx="42">
                  <c:v>210.0</c:v>
                </c:pt>
                <c:pt idx="43">
                  <c:v>215.0</c:v>
                </c:pt>
                <c:pt idx="44">
                  <c:v>220.0</c:v>
                </c:pt>
                <c:pt idx="45">
                  <c:v>225.0</c:v>
                </c:pt>
                <c:pt idx="46">
                  <c:v>230.0</c:v>
                </c:pt>
                <c:pt idx="47">
                  <c:v>235.0</c:v>
                </c:pt>
                <c:pt idx="48">
                  <c:v>240.0</c:v>
                </c:pt>
                <c:pt idx="49">
                  <c:v>245.0</c:v>
                </c:pt>
                <c:pt idx="50">
                  <c:v>250.0</c:v>
                </c:pt>
                <c:pt idx="51">
                  <c:v>255.0</c:v>
                </c:pt>
                <c:pt idx="52">
                  <c:v>260.0</c:v>
                </c:pt>
                <c:pt idx="53">
                  <c:v>265.0</c:v>
                </c:pt>
                <c:pt idx="54">
                  <c:v>270.0</c:v>
                </c:pt>
                <c:pt idx="55">
                  <c:v>275.0</c:v>
                </c:pt>
                <c:pt idx="56">
                  <c:v>280.0</c:v>
                </c:pt>
                <c:pt idx="57">
                  <c:v>285.0</c:v>
                </c:pt>
                <c:pt idx="58">
                  <c:v>290.0</c:v>
                </c:pt>
                <c:pt idx="59">
                  <c:v>295.0</c:v>
                </c:pt>
                <c:pt idx="60">
                  <c:v>300.0</c:v>
                </c:pt>
                <c:pt idx="61">
                  <c:v>305.0</c:v>
                </c:pt>
                <c:pt idx="62">
                  <c:v>310.0</c:v>
                </c:pt>
                <c:pt idx="63">
                  <c:v>315.0</c:v>
                </c:pt>
                <c:pt idx="64">
                  <c:v>320.0</c:v>
                </c:pt>
                <c:pt idx="65">
                  <c:v>325.0</c:v>
                </c:pt>
                <c:pt idx="66">
                  <c:v>330.0</c:v>
                </c:pt>
                <c:pt idx="67">
                  <c:v>335.0</c:v>
                </c:pt>
                <c:pt idx="68">
                  <c:v>340.0</c:v>
                </c:pt>
                <c:pt idx="69">
                  <c:v>345.0</c:v>
                </c:pt>
                <c:pt idx="70">
                  <c:v>350.0</c:v>
                </c:pt>
                <c:pt idx="71">
                  <c:v>355.0</c:v>
                </c:pt>
                <c:pt idx="72">
                  <c:v>360.0</c:v>
                </c:pt>
                <c:pt idx="73">
                  <c:v>365.0</c:v>
                </c:pt>
                <c:pt idx="74">
                  <c:v>370.0</c:v>
                </c:pt>
                <c:pt idx="75">
                  <c:v>375.0</c:v>
                </c:pt>
                <c:pt idx="76">
                  <c:v>380.0</c:v>
                </c:pt>
                <c:pt idx="77">
                  <c:v>385.0</c:v>
                </c:pt>
                <c:pt idx="78">
                  <c:v>390.0</c:v>
                </c:pt>
                <c:pt idx="79">
                  <c:v>395.0</c:v>
                </c:pt>
                <c:pt idx="80">
                  <c:v>400.0</c:v>
                </c:pt>
                <c:pt idx="81">
                  <c:v>405.0</c:v>
                </c:pt>
                <c:pt idx="82">
                  <c:v>410.0</c:v>
                </c:pt>
                <c:pt idx="83">
                  <c:v>415.0</c:v>
                </c:pt>
                <c:pt idx="84">
                  <c:v>420.0</c:v>
                </c:pt>
                <c:pt idx="85">
                  <c:v>425.0</c:v>
                </c:pt>
                <c:pt idx="86">
                  <c:v>430.0</c:v>
                </c:pt>
                <c:pt idx="87">
                  <c:v>435.0</c:v>
                </c:pt>
                <c:pt idx="88">
                  <c:v>440.0</c:v>
                </c:pt>
                <c:pt idx="89">
                  <c:v>445.0</c:v>
                </c:pt>
                <c:pt idx="90">
                  <c:v>450.0</c:v>
                </c:pt>
                <c:pt idx="91">
                  <c:v>455.0</c:v>
                </c:pt>
                <c:pt idx="92">
                  <c:v>460.0</c:v>
                </c:pt>
                <c:pt idx="93">
                  <c:v>465.0</c:v>
                </c:pt>
                <c:pt idx="94">
                  <c:v>470.0</c:v>
                </c:pt>
                <c:pt idx="95">
                  <c:v>475.0</c:v>
                </c:pt>
                <c:pt idx="96">
                  <c:v>480.0</c:v>
                </c:pt>
                <c:pt idx="97">
                  <c:v>485.0</c:v>
                </c:pt>
                <c:pt idx="98">
                  <c:v>490.0</c:v>
                </c:pt>
                <c:pt idx="99">
                  <c:v>495.0</c:v>
                </c:pt>
                <c:pt idx="100">
                  <c:v>500.0</c:v>
                </c:pt>
              </c:numCache>
            </c:numRef>
          </c:cat>
          <c:val>
            <c:numRef>
              <c:f>'Feuil1 (2)'!$C$1:$C$100</c:f>
              <c:numCache>
                <c:formatCode>General</c:formatCode>
                <c:ptCount val="100"/>
                <c:pt idx="0">
                  <c:v>0.37</c:v>
                </c:pt>
                <c:pt idx="1">
                  <c:v>0.37</c:v>
                </c:pt>
                <c:pt idx="2">
                  <c:v>0.37</c:v>
                </c:pt>
                <c:pt idx="3">
                  <c:v>0.37</c:v>
                </c:pt>
                <c:pt idx="4">
                  <c:v>0.37</c:v>
                </c:pt>
                <c:pt idx="5">
                  <c:v>0.37</c:v>
                </c:pt>
                <c:pt idx="6">
                  <c:v>0.37</c:v>
                </c:pt>
                <c:pt idx="7">
                  <c:v>0.37</c:v>
                </c:pt>
                <c:pt idx="8">
                  <c:v>0.37</c:v>
                </c:pt>
                <c:pt idx="9">
                  <c:v>0.37</c:v>
                </c:pt>
                <c:pt idx="10">
                  <c:v>0.37</c:v>
                </c:pt>
                <c:pt idx="11">
                  <c:v>0.37</c:v>
                </c:pt>
                <c:pt idx="12">
                  <c:v>0.37</c:v>
                </c:pt>
                <c:pt idx="13">
                  <c:v>0.37</c:v>
                </c:pt>
                <c:pt idx="14">
                  <c:v>0.37</c:v>
                </c:pt>
                <c:pt idx="15">
                  <c:v>0.36</c:v>
                </c:pt>
                <c:pt idx="16">
                  <c:v>0.37</c:v>
                </c:pt>
                <c:pt idx="17">
                  <c:v>0.36</c:v>
                </c:pt>
                <c:pt idx="18">
                  <c:v>0.37</c:v>
                </c:pt>
                <c:pt idx="19">
                  <c:v>0.37</c:v>
                </c:pt>
                <c:pt idx="20">
                  <c:v>0.37</c:v>
                </c:pt>
                <c:pt idx="21">
                  <c:v>0.37</c:v>
                </c:pt>
                <c:pt idx="22">
                  <c:v>0.37</c:v>
                </c:pt>
                <c:pt idx="23">
                  <c:v>0.37</c:v>
                </c:pt>
                <c:pt idx="24">
                  <c:v>0.37</c:v>
                </c:pt>
                <c:pt idx="25">
                  <c:v>0.38</c:v>
                </c:pt>
                <c:pt idx="26">
                  <c:v>0.39</c:v>
                </c:pt>
                <c:pt idx="27">
                  <c:v>0.39</c:v>
                </c:pt>
                <c:pt idx="28">
                  <c:v>0.4</c:v>
                </c:pt>
                <c:pt idx="29">
                  <c:v>0.42</c:v>
                </c:pt>
                <c:pt idx="30">
                  <c:v>0.45</c:v>
                </c:pt>
                <c:pt idx="31">
                  <c:v>0.48</c:v>
                </c:pt>
                <c:pt idx="32">
                  <c:v>0.51</c:v>
                </c:pt>
                <c:pt idx="33">
                  <c:v>0.54</c:v>
                </c:pt>
                <c:pt idx="34">
                  <c:v>0.58</c:v>
                </c:pt>
                <c:pt idx="35">
                  <c:v>0.59</c:v>
                </c:pt>
                <c:pt idx="36">
                  <c:v>0.6</c:v>
                </c:pt>
                <c:pt idx="37">
                  <c:v>0.6</c:v>
                </c:pt>
                <c:pt idx="38">
                  <c:v>0.6</c:v>
                </c:pt>
                <c:pt idx="39">
                  <c:v>0.59</c:v>
                </c:pt>
                <c:pt idx="40">
                  <c:v>0.58</c:v>
                </c:pt>
                <c:pt idx="41">
                  <c:v>0.57</c:v>
                </c:pt>
                <c:pt idx="42">
                  <c:v>0.57</c:v>
                </c:pt>
                <c:pt idx="43">
                  <c:v>0.56</c:v>
                </c:pt>
                <c:pt idx="44">
                  <c:v>0.57</c:v>
                </c:pt>
                <c:pt idx="45">
                  <c:v>0.55</c:v>
                </c:pt>
                <c:pt idx="46">
                  <c:v>0.55</c:v>
                </c:pt>
                <c:pt idx="47">
                  <c:v>0.53</c:v>
                </c:pt>
                <c:pt idx="48">
                  <c:v>0.54</c:v>
                </c:pt>
                <c:pt idx="49">
                  <c:v>0.53</c:v>
                </c:pt>
                <c:pt idx="50">
                  <c:v>0.52</c:v>
                </c:pt>
                <c:pt idx="51">
                  <c:v>0.51</c:v>
                </c:pt>
                <c:pt idx="52">
                  <c:v>0.51</c:v>
                </c:pt>
                <c:pt idx="53">
                  <c:v>0.5</c:v>
                </c:pt>
                <c:pt idx="54">
                  <c:v>0.5</c:v>
                </c:pt>
                <c:pt idx="55">
                  <c:v>0.49</c:v>
                </c:pt>
                <c:pt idx="56">
                  <c:v>0.48</c:v>
                </c:pt>
                <c:pt idx="57">
                  <c:v>0.47</c:v>
                </c:pt>
                <c:pt idx="58">
                  <c:v>0.46</c:v>
                </c:pt>
                <c:pt idx="59">
                  <c:v>0.46</c:v>
                </c:pt>
                <c:pt idx="60">
                  <c:v>0.45</c:v>
                </c:pt>
                <c:pt idx="61">
                  <c:v>0.44</c:v>
                </c:pt>
                <c:pt idx="62">
                  <c:v>0.44</c:v>
                </c:pt>
                <c:pt idx="63">
                  <c:v>0.44</c:v>
                </c:pt>
                <c:pt idx="64">
                  <c:v>0.43</c:v>
                </c:pt>
                <c:pt idx="65">
                  <c:v>0.43</c:v>
                </c:pt>
                <c:pt idx="66">
                  <c:v>0.43</c:v>
                </c:pt>
                <c:pt idx="67">
                  <c:v>0.42</c:v>
                </c:pt>
                <c:pt idx="68">
                  <c:v>0.42</c:v>
                </c:pt>
                <c:pt idx="69">
                  <c:v>0.42</c:v>
                </c:pt>
                <c:pt idx="70">
                  <c:v>0.41</c:v>
                </c:pt>
                <c:pt idx="71">
                  <c:v>0.41</c:v>
                </c:pt>
                <c:pt idx="72">
                  <c:v>0.4</c:v>
                </c:pt>
                <c:pt idx="73">
                  <c:v>0.4</c:v>
                </c:pt>
                <c:pt idx="74">
                  <c:v>0.4</c:v>
                </c:pt>
                <c:pt idx="75">
                  <c:v>0.4</c:v>
                </c:pt>
                <c:pt idx="76">
                  <c:v>0.39</c:v>
                </c:pt>
                <c:pt idx="77">
                  <c:v>0.39</c:v>
                </c:pt>
                <c:pt idx="78">
                  <c:v>0.39</c:v>
                </c:pt>
                <c:pt idx="79">
                  <c:v>0.39</c:v>
                </c:pt>
                <c:pt idx="80">
                  <c:v>0.39</c:v>
                </c:pt>
                <c:pt idx="81">
                  <c:v>0.39</c:v>
                </c:pt>
                <c:pt idx="82">
                  <c:v>0.39</c:v>
                </c:pt>
                <c:pt idx="83">
                  <c:v>0.38</c:v>
                </c:pt>
                <c:pt idx="84">
                  <c:v>0.38</c:v>
                </c:pt>
                <c:pt idx="85">
                  <c:v>0.38</c:v>
                </c:pt>
                <c:pt idx="86">
                  <c:v>0.38</c:v>
                </c:pt>
                <c:pt idx="87">
                  <c:v>0.38</c:v>
                </c:pt>
                <c:pt idx="88">
                  <c:v>0.38</c:v>
                </c:pt>
                <c:pt idx="89">
                  <c:v>0.38</c:v>
                </c:pt>
                <c:pt idx="90">
                  <c:v>0.38</c:v>
                </c:pt>
                <c:pt idx="91">
                  <c:v>0.38</c:v>
                </c:pt>
                <c:pt idx="92">
                  <c:v>0.38</c:v>
                </c:pt>
                <c:pt idx="93">
                  <c:v>0.38</c:v>
                </c:pt>
                <c:pt idx="94">
                  <c:v>0.38</c:v>
                </c:pt>
                <c:pt idx="95">
                  <c:v>0.38</c:v>
                </c:pt>
                <c:pt idx="96">
                  <c:v>0.37</c:v>
                </c:pt>
                <c:pt idx="97">
                  <c:v>0.37</c:v>
                </c:pt>
                <c:pt idx="98">
                  <c:v>0.37</c:v>
                </c:pt>
                <c:pt idx="99">
                  <c:v>0.3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44220200"/>
        <c:axId val="-2144214520"/>
      </c:lineChart>
      <c:catAx>
        <c:axId val="-21442202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algn="ctr" rtl="0">
                  <a:defRPr lang="en-US" sz="800" b="0" i="0" u="none" strike="noStrike" kern="1200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0" i="0" u="none" strike="noStrike" kern="1200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Time (sec)</a:t>
                </a:r>
              </a:p>
            </c:rich>
          </c:tx>
          <c:layout>
            <c:manualLayout>
              <c:xMode val="edge"/>
              <c:yMode val="edge"/>
              <c:x val="0.464527109588835"/>
              <c:y val="0.91530092614301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algn="ctr" rtl="0">
              <a:defRPr lang="en-US" sz="800" b="0" i="0" u="none" strike="noStrike" kern="1200" baseline="0">
                <a:solidFill>
                  <a:sysClr val="windowText" lastClr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-2144214520"/>
        <c:crosses val="autoZero"/>
        <c:auto val="1"/>
        <c:lblAlgn val="ctr"/>
        <c:lblOffset val="100"/>
        <c:tickLblSkip val="10"/>
        <c:tickMarkSkip val="5"/>
        <c:noMultiLvlLbl val="0"/>
      </c:catAx>
      <c:valAx>
        <c:axId val="-2144214520"/>
        <c:scaling>
          <c:orientation val="minMax"/>
          <c:max val="0.7"/>
          <c:min val="0.2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2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800" b="1" i="0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uorescence ratio (F340/F380)</a:t>
                </a:r>
                <a:endParaRPr lang="en-US" sz="200" b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#,##0.00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algn="ctr" rtl="0">
              <a:defRPr lang="en-US" sz="800" b="0" i="0" u="none" strike="noStrike" kern="1200" baseline="0">
                <a:solidFill>
                  <a:sysClr val="windowText" lastClr="00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-21442202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31054821341165"/>
          <c:y val="0.0982419127988748"/>
          <c:w val="0.611961984010442"/>
          <c:h val="0.64763994374121"/>
        </c:manualLayout>
      </c:layout>
      <c:lineChart>
        <c:grouping val="standard"/>
        <c:varyColors val="0"/>
        <c:ser>
          <c:idx val="0"/>
          <c:order val="0"/>
          <c:tx>
            <c:v>without AO pretreatment</c:v>
          </c:tx>
          <c:spPr>
            <a:ln>
              <a:solidFill>
                <a:schemeClr val="bg1"/>
              </a:solidFill>
            </a:ln>
          </c:spPr>
          <c:marker>
            <c:symbol val="none"/>
          </c:marker>
          <c:trendline>
            <c:spPr>
              <a:ln w="12700">
                <a:solidFill>
                  <a:schemeClr val="tx1"/>
                </a:solidFill>
              </a:ln>
            </c:spPr>
            <c:trendlineType val="movingAvg"/>
            <c:period val="4"/>
            <c:dispRSqr val="0"/>
            <c:dispEq val="0"/>
          </c:trendline>
          <c:cat>
            <c:numRef>
              <c:f>Feuil2!$A$1:$A$201</c:f>
              <c:numCache>
                <c:formatCode>General</c:formatCode>
                <c:ptCount val="201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15.0</c:v>
                </c:pt>
                <c:pt idx="4">
                  <c:v>20.0</c:v>
                </c:pt>
                <c:pt idx="5">
                  <c:v>25.0</c:v>
                </c:pt>
                <c:pt idx="6">
                  <c:v>30.0</c:v>
                </c:pt>
                <c:pt idx="7">
                  <c:v>35.0</c:v>
                </c:pt>
                <c:pt idx="8">
                  <c:v>40.0</c:v>
                </c:pt>
                <c:pt idx="9">
                  <c:v>45.0</c:v>
                </c:pt>
                <c:pt idx="10">
                  <c:v>50.0</c:v>
                </c:pt>
                <c:pt idx="11">
                  <c:v>55.0</c:v>
                </c:pt>
                <c:pt idx="12">
                  <c:v>60.0</c:v>
                </c:pt>
                <c:pt idx="13">
                  <c:v>65.0</c:v>
                </c:pt>
                <c:pt idx="14">
                  <c:v>70.0</c:v>
                </c:pt>
                <c:pt idx="15">
                  <c:v>75.0</c:v>
                </c:pt>
                <c:pt idx="16">
                  <c:v>80.0</c:v>
                </c:pt>
                <c:pt idx="17">
                  <c:v>85.0</c:v>
                </c:pt>
                <c:pt idx="18">
                  <c:v>90.0</c:v>
                </c:pt>
                <c:pt idx="19">
                  <c:v>95.0</c:v>
                </c:pt>
                <c:pt idx="20">
                  <c:v>100.0</c:v>
                </c:pt>
                <c:pt idx="21">
                  <c:v>105.0</c:v>
                </c:pt>
                <c:pt idx="22">
                  <c:v>110.0</c:v>
                </c:pt>
                <c:pt idx="23">
                  <c:v>115.0</c:v>
                </c:pt>
                <c:pt idx="24">
                  <c:v>120.0</c:v>
                </c:pt>
                <c:pt idx="25">
                  <c:v>125.0</c:v>
                </c:pt>
                <c:pt idx="26">
                  <c:v>130.0</c:v>
                </c:pt>
                <c:pt idx="27">
                  <c:v>135.0</c:v>
                </c:pt>
                <c:pt idx="28">
                  <c:v>140.0</c:v>
                </c:pt>
                <c:pt idx="29">
                  <c:v>145.0</c:v>
                </c:pt>
                <c:pt idx="30">
                  <c:v>150.0</c:v>
                </c:pt>
                <c:pt idx="31">
                  <c:v>155.0</c:v>
                </c:pt>
                <c:pt idx="32">
                  <c:v>160.0</c:v>
                </c:pt>
                <c:pt idx="33">
                  <c:v>165.0</c:v>
                </c:pt>
                <c:pt idx="34">
                  <c:v>170.0</c:v>
                </c:pt>
                <c:pt idx="35">
                  <c:v>175.0</c:v>
                </c:pt>
                <c:pt idx="36">
                  <c:v>180.0</c:v>
                </c:pt>
                <c:pt idx="37">
                  <c:v>185.0</c:v>
                </c:pt>
                <c:pt idx="38">
                  <c:v>190.0</c:v>
                </c:pt>
                <c:pt idx="39">
                  <c:v>195.0</c:v>
                </c:pt>
                <c:pt idx="40">
                  <c:v>200.0</c:v>
                </c:pt>
                <c:pt idx="41">
                  <c:v>205.0</c:v>
                </c:pt>
                <c:pt idx="42">
                  <c:v>210.0</c:v>
                </c:pt>
                <c:pt idx="43">
                  <c:v>215.0</c:v>
                </c:pt>
                <c:pt idx="44">
                  <c:v>220.0</c:v>
                </c:pt>
                <c:pt idx="45">
                  <c:v>225.0</c:v>
                </c:pt>
                <c:pt idx="46">
                  <c:v>230.0</c:v>
                </c:pt>
                <c:pt idx="47">
                  <c:v>235.0</c:v>
                </c:pt>
                <c:pt idx="48">
                  <c:v>240.0</c:v>
                </c:pt>
                <c:pt idx="49">
                  <c:v>245.0</c:v>
                </c:pt>
                <c:pt idx="50">
                  <c:v>250.0</c:v>
                </c:pt>
                <c:pt idx="51">
                  <c:v>255.0</c:v>
                </c:pt>
                <c:pt idx="52">
                  <c:v>260.0</c:v>
                </c:pt>
                <c:pt idx="53">
                  <c:v>265.0</c:v>
                </c:pt>
                <c:pt idx="54">
                  <c:v>270.0</c:v>
                </c:pt>
                <c:pt idx="55">
                  <c:v>275.0</c:v>
                </c:pt>
                <c:pt idx="56">
                  <c:v>280.0</c:v>
                </c:pt>
                <c:pt idx="57">
                  <c:v>285.0</c:v>
                </c:pt>
                <c:pt idx="58">
                  <c:v>290.0</c:v>
                </c:pt>
                <c:pt idx="59">
                  <c:v>295.0</c:v>
                </c:pt>
                <c:pt idx="60">
                  <c:v>300.0</c:v>
                </c:pt>
                <c:pt idx="61">
                  <c:v>305.0</c:v>
                </c:pt>
                <c:pt idx="62">
                  <c:v>310.0</c:v>
                </c:pt>
                <c:pt idx="63">
                  <c:v>315.0</c:v>
                </c:pt>
                <c:pt idx="64">
                  <c:v>320.0</c:v>
                </c:pt>
                <c:pt idx="65">
                  <c:v>325.0</c:v>
                </c:pt>
                <c:pt idx="66">
                  <c:v>330.0</c:v>
                </c:pt>
                <c:pt idx="67">
                  <c:v>335.0</c:v>
                </c:pt>
                <c:pt idx="68">
                  <c:v>340.0</c:v>
                </c:pt>
                <c:pt idx="69">
                  <c:v>345.0</c:v>
                </c:pt>
                <c:pt idx="70">
                  <c:v>350.0</c:v>
                </c:pt>
                <c:pt idx="71">
                  <c:v>355.0</c:v>
                </c:pt>
                <c:pt idx="72">
                  <c:v>360.0</c:v>
                </c:pt>
                <c:pt idx="73">
                  <c:v>365.0</c:v>
                </c:pt>
                <c:pt idx="74">
                  <c:v>370.0</c:v>
                </c:pt>
                <c:pt idx="75">
                  <c:v>375.0</c:v>
                </c:pt>
                <c:pt idx="76">
                  <c:v>380.0</c:v>
                </c:pt>
                <c:pt idx="77">
                  <c:v>385.0</c:v>
                </c:pt>
                <c:pt idx="78">
                  <c:v>390.0</c:v>
                </c:pt>
                <c:pt idx="79">
                  <c:v>395.0</c:v>
                </c:pt>
                <c:pt idx="80">
                  <c:v>400.0</c:v>
                </c:pt>
                <c:pt idx="81">
                  <c:v>405.0</c:v>
                </c:pt>
                <c:pt idx="82">
                  <c:v>410.0</c:v>
                </c:pt>
                <c:pt idx="83">
                  <c:v>415.0</c:v>
                </c:pt>
                <c:pt idx="84">
                  <c:v>420.0</c:v>
                </c:pt>
                <c:pt idx="85">
                  <c:v>425.0</c:v>
                </c:pt>
                <c:pt idx="86">
                  <c:v>430.0</c:v>
                </c:pt>
                <c:pt idx="87">
                  <c:v>435.0</c:v>
                </c:pt>
                <c:pt idx="88">
                  <c:v>440.0</c:v>
                </c:pt>
                <c:pt idx="89">
                  <c:v>445.0</c:v>
                </c:pt>
                <c:pt idx="90">
                  <c:v>450.0</c:v>
                </c:pt>
                <c:pt idx="91">
                  <c:v>455.0</c:v>
                </c:pt>
                <c:pt idx="92">
                  <c:v>460.0</c:v>
                </c:pt>
                <c:pt idx="93">
                  <c:v>465.0</c:v>
                </c:pt>
                <c:pt idx="94">
                  <c:v>470.0</c:v>
                </c:pt>
                <c:pt idx="95">
                  <c:v>475.0</c:v>
                </c:pt>
                <c:pt idx="96">
                  <c:v>480.0</c:v>
                </c:pt>
                <c:pt idx="97">
                  <c:v>485.0</c:v>
                </c:pt>
                <c:pt idx="98">
                  <c:v>490.0</c:v>
                </c:pt>
                <c:pt idx="99">
                  <c:v>495.0</c:v>
                </c:pt>
                <c:pt idx="100">
                  <c:v>500.0</c:v>
                </c:pt>
                <c:pt idx="101">
                  <c:v>505.0</c:v>
                </c:pt>
                <c:pt idx="102">
                  <c:v>510.0</c:v>
                </c:pt>
                <c:pt idx="103">
                  <c:v>515.0</c:v>
                </c:pt>
                <c:pt idx="104">
                  <c:v>520.0</c:v>
                </c:pt>
                <c:pt idx="105">
                  <c:v>525.0</c:v>
                </c:pt>
                <c:pt idx="106">
                  <c:v>530.0</c:v>
                </c:pt>
                <c:pt idx="107">
                  <c:v>535.0</c:v>
                </c:pt>
                <c:pt idx="108">
                  <c:v>540.0</c:v>
                </c:pt>
                <c:pt idx="109">
                  <c:v>545.0</c:v>
                </c:pt>
                <c:pt idx="110">
                  <c:v>550.0</c:v>
                </c:pt>
                <c:pt idx="111">
                  <c:v>555.0</c:v>
                </c:pt>
                <c:pt idx="112">
                  <c:v>560.0</c:v>
                </c:pt>
                <c:pt idx="113">
                  <c:v>565.0</c:v>
                </c:pt>
                <c:pt idx="114">
                  <c:v>570.0</c:v>
                </c:pt>
                <c:pt idx="115">
                  <c:v>575.0</c:v>
                </c:pt>
                <c:pt idx="116">
                  <c:v>580.0</c:v>
                </c:pt>
                <c:pt idx="117">
                  <c:v>585.0</c:v>
                </c:pt>
                <c:pt idx="118">
                  <c:v>590.0</c:v>
                </c:pt>
                <c:pt idx="119">
                  <c:v>595.0</c:v>
                </c:pt>
                <c:pt idx="120">
                  <c:v>600.0</c:v>
                </c:pt>
                <c:pt idx="121">
                  <c:v>605.0</c:v>
                </c:pt>
                <c:pt idx="122">
                  <c:v>610.0</c:v>
                </c:pt>
                <c:pt idx="123">
                  <c:v>615.0</c:v>
                </c:pt>
                <c:pt idx="124">
                  <c:v>620.0</c:v>
                </c:pt>
                <c:pt idx="125">
                  <c:v>625.0</c:v>
                </c:pt>
                <c:pt idx="126">
                  <c:v>630.0</c:v>
                </c:pt>
                <c:pt idx="127">
                  <c:v>635.0</c:v>
                </c:pt>
                <c:pt idx="128">
                  <c:v>640.0</c:v>
                </c:pt>
                <c:pt idx="129">
                  <c:v>645.0</c:v>
                </c:pt>
                <c:pt idx="130">
                  <c:v>650.0</c:v>
                </c:pt>
                <c:pt idx="131">
                  <c:v>655.0</c:v>
                </c:pt>
                <c:pt idx="132">
                  <c:v>660.0</c:v>
                </c:pt>
                <c:pt idx="133">
                  <c:v>665.0</c:v>
                </c:pt>
                <c:pt idx="134">
                  <c:v>670.0</c:v>
                </c:pt>
                <c:pt idx="135">
                  <c:v>675.0</c:v>
                </c:pt>
                <c:pt idx="136">
                  <c:v>680.0</c:v>
                </c:pt>
                <c:pt idx="137">
                  <c:v>685.0</c:v>
                </c:pt>
                <c:pt idx="138">
                  <c:v>690.0</c:v>
                </c:pt>
                <c:pt idx="139">
                  <c:v>695.0</c:v>
                </c:pt>
                <c:pt idx="140">
                  <c:v>700.0</c:v>
                </c:pt>
                <c:pt idx="141">
                  <c:v>705.0</c:v>
                </c:pt>
                <c:pt idx="142">
                  <c:v>710.0</c:v>
                </c:pt>
                <c:pt idx="143">
                  <c:v>715.0</c:v>
                </c:pt>
                <c:pt idx="144">
                  <c:v>720.0</c:v>
                </c:pt>
                <c:pt idx="145">
                  <c:v>725.0</c:v>
                </c:pt>
                <c:pt idx="146">
                  <c:v>730.0</c:v>
                </c:pt>
                <c:pt idx="147">
                  <c:v>735.0</c:v>
                </c:pt>
                <c:pt idx="148">
                  <c:v>740.0</c:v>
                </c:pt>
                <c:pt idx="149">
                  <c:v>745.0</c:v>
                </c:pt>
                <c:pt idx="150">
                  <c:v>750.0</c:v>
                </c:pt>
                <c:pt idx="151">
                  <c:v>755.0</c:v>
                </c:pt>
                <c:pt idx="152">
                  <c:v>760.0</c:v>
                </c:pt>
                <c:pt idx="153">
                  <c:v>765.0</c:v>
                </c:pt>
                <c:pt idx="154">
                  <c:v>770.0</c:v>
                </c:pt>
                <c:pt idx="155">
                  <c:v>775.0</c:v>
                </c:pt>
                <c:pt idx="156">
                  <c:v>780.0</c:v>
                </c:pt>
                <c:pt idx="157">
                  <c:v>785.0</c:v>
                </c:pt>
                <c:pt idx="158">
                  <c:v>790.0</c:v>
                </c:pt>
                <c:pt idx="159">
                  <c:v>795.0</c:v>
                </c:pt>
                <c:pt idx="160">
                  <c:v>800.0</c:v>
                </c:pt>
                <c:pt idx="161">
                  <c:v>805.0</c:v>
                </c:pt>
                <c:pt idx="162">
                  <c:v>810.0</c:v>
                </c:pt>
                <c:pt idx="163">
                  <c:v>815.0</c:v>
                </c:pt>
                <c:pt idx="164">
                  <c:v>820.0</c:v>
                </c:pt>
                <c:pt idx="165">
                  <c:v>825.0</c:v>
                </c:pt>
                <c:pt idx="166">
                  <c:v>830.0</c:v>
                </c:pt>
                <c:pt idx="167">
                  <c:v>835.0</c:v>
                </c:pt>
                <c:pt idx="168">
                  <c:v>840.0</c:v>
                </c:pt>
                <c:pt idx="169">
                  <c:v>845.0</c:v>
                </c:pt>
                <c:pt idx="170">
                  <c:v>850.0</c:v>
                </c:pt>
                <c:pt idx="171">
                  <c:v>855.0</c:v>
                </c:pt>
                <c:pt idx="172">
                  <c:v>860.0</c:v>
                </c:pt>
                <c:pt idx="173">
                  <c:v>865.0</c:v>
                </c:pt>
                <c:pt idx="174">
                  <c:v>870.0</c:v>
                </c:pt>
                <c:pt idx="175">
                  <c:v>875.0</c:v>
                </c:pt>
                <c:pt idx="176">
                  <c:v>880.0</c:v>
                </c:pt>
                <c:pt idx="177">
                  <c:v>885.0</c:v>
                </c:pt>
                <c:pt idx="178">
                  <c:v>890.0</c:v>
                </c:pt>
                <c:pt idx="179">
                  <c:v>895.0</c:v>
                </c:pt>
                <c:pt idx="180">
                  <c:v>900.0</c:v>
                </c:pt>
                <c:pt idx="181">
                  <c:v>905.0</c:v>
                </c:pt>
                <c:pt idx="182">
                  <c:v>910.0</c:v>
                </c:pt>
                <c:pt idx="183">
                  <c:v>915.0</c:v>
                </c:pt>
                <c:pt idx="184">
                  <c:v>920.0</c:v>
                </c:pt>
                <c:pt idx="185">
                  <c:v>925.0</c:v>
                </c:pt>
                <c:pt idx="186">
                  <c:v>930.0</c:v>
                </c:pt>
                <c:pt idx="187">
                  <c:v>935.0</c:v>
                </c:pt>
                <c:pt idx="188">
                  <c:v>940.0</c:v>
                </c:pt>
                <c:pt idx="189">
                  <c:v>945.0</c:v>
                </c:pt>
                <c:pt idx="190">
                  <c:v>950.0</c:v>
                </c:pt>
                <c:pt idx="191">
                  <c:v>955.0</c:v>
                </c:pt>
                <c:pt idx="192">
                  <c:v>960.0</c:v>
                </c:pt>
                <c:pt idx="193">
                  <c:v>965.0</c:v>
                </c:pt>
                <c:pt idx="194">
                  <c:v>970.0</c:v>
                </c:pt>
                <c:pt idx="195">
                  <c:v>975.0</c:v>
                </c:pt>
                <c:pt idx="196">
                  <c:v>980.0</c:v>
                </c:pt>
                <c:pt idx="197">
                  <c:v>985.0</c:v>
                </c:pt>
                <c:pt idx="198">
                  <c:v>990.0</c:v>
                </c:pt>
                <c:pt idx="199">
                  <c:v>995.0</c:v>
                </c:pt>
                <c:pt idx="200">
                  <c:v>1000.0</c:v>
                </c:pt>
              </c:numCache>
            </c:numRef>
          </c:cat>
          <c:val>
            <c:numRef>
              <c:f>Feuil2!$B$1:$B$201</c:f>
              <c:numCache>
                <c:formatCode>General</c:formatCode>
                <c:ptCount val="201"/>
                <c:pt idx="0">
                  <c:v>0.343702862877822</c:v>
                </c:pt>
                <c:pt idx="1">
                  <c:v>0.343459793255926</c:v>
                </c:pt>
                <c:pt idx="2">
                  <c:v>0.342240100917565</c:v>
                </c:pt>
                <c:pt idx="3">
                  <c:v>0.342410696647493</c:v>
                </c:pt>
                <c:pt idx="4">
                  <c:v>0.342251621872104</c:v>
                </c:pt>
                <c:pt idx="5">
                  <c:v>0.341942079694639</c:v>
                </c:pt>
                <c:pt idx="6">
                  <c:v>0.342112992137407</c:v>
                </c:pt>
                <c:pt idx="7">
                  <c:v>0.342802710098099</c:v>
                </c:pt>
                <c:pt idx="8">
                  <c:v>0.342293870977103</c:v>
                </c:pt>
                <c:pt idx="9">
                  <c:v>0.34204034904318</c:v>
                </c:pt>
                <c:pt idx="10">
                  <c:v>0.34275848450024</c:v>
                </c:pt>
                <c:pt idx="11">
                  <c:v>0.341489553105049</c:v>
                </c:pt>
                <c:pt idx="12">
                  <c:v>0.34116219808159</c:v>
                </c:pt>
                <c:pt idx="13">
                  <c:v>0.34106704604541</c:v>
                </c:pt>
                <c:pt idx="14">
                  <c:v>0.341850123864575</c:v>
                </c:pt>
                <c:pt idx="15">
                  <c:v>0.341094406605643</c:v>
                </c:pt>
                <c:pt idx="16">
                  <c:v>0.341628050106563</c:v>
                </c:pt>
                <c:pt idx="17">
                  <c:v>0.341390038735041</c:v>
                </c:pt>
                <c:pt idx="18">
                  <c:v>0.340549733314113</c:v>
                </c:pt>
                <c:pt idx="19">
                  <c:v>0.34058918296893</c:v>
                </c:pt>
                <c:pt idx="20">
                  <c:v>0.340783981211999</c:v>
                </c:pt>
                <c:pt idx="21">
                  <c:v>0.340988264062207</c:v>
                </c:pt>
                <c:pt idx="22">
                  <c:v>0.34135399389229</c:v>
                </c:pt>
                <c:pt idx="23">
                  <c:v>0.34113974184586</c:v>
                </c:pt>
                <c:pt idx="24">
                  <c:v>0.340232773787892</c:v>
                </c:pt>
                <c:pt idx="25">
                  <c:v>0.34061134142304</c:v>
                </c:pt>
                <c:pt idx="26">
                  <c:v>0.340927721370904</c:v>
                </c:pt>
                <c:pt idx="27">
                  <c:v>0.341069380891205</c:v>
                </c:pt>
                <c:pt idx="28">
                  <c:v>0.34109831525502</c:v>
                </c:pt>
                <c:pt idx="29">
                  <c:v>0.341613606723663</c:v>
                </c:pt>
                <c:pt idx="30">
                  <c:v>0.341414177218845</c:v>
                </c:pt>
                <c:pt idx="31">
                  <c:v>0.340166551386247</c:v>
                </c:pt>
                <c:pt idx="32">
                  <c:v>0.340184779627251</c:v>
                </c:pt>
                <c:pt idx="33">
                  <c:v>0.340335809785565</c:v>
                </c:pt>
                <c:pt idx="34">
                  <c:v>0.339601424762778</c:v>
                </c:pt>
                <c:pt idx="35">
                  <c:v>0.343031780408313</c:v>
                </c:pt>
                <c:pt idx="36">
                  <c:v>0.344550343249428</c:v>
                </c:pt>
                <c:pt idx="37">
                  <c:v>0.346582670606811</c:v>
                </c:pt>
                <c:pt idx="38">
                  <c:v>0.347672123398252</c:v>
                </c:pt>
                <c:pt idx="39">
                  <c:v>0.347782164936428</c:v>
                </c:pt>
                <c:pt idx="40">
                  <c:v>0.349509882788947</c:v>
                </c:pt>
                <c:pt idx="41">
                  <c:v>0.348644136867611</c:v>
                </c:pt>
                <c:pt idx="42">
                  <c:v>0.3502107793035</c:v>
                </c:pt>
                <c:pt idx="43">
                  <c:v>0.350536748875262</c:v>
                </c:pt>
                <c:pt idx="44">
                  <c:v>0.350490691786432</c:v>
                </c:pt>
                <c:pt idx="45">
                  <c:v>0.350635489250194</c:v>
                </c:pt>
                <c:pt idx="46">
                  <c:v>0.352075707254312</c:v>
                </c:pt>
                <c:pt idx="47">
                  <c:v>0.351676911544228</c:v>
                </c:pt>
                <c:pt idx="48">
                  <c:v>0.351802997569538</c:v>
                </c:pt>
                <c:pt idx="49">
                  <c:v>0.351552892264281</c:v>
                </c:pt>
                <c:pt idx="50">
                  <c:v>0.352016007532957</c:v>
                </c:pt>
                <c:pt idx="51">
                  <c:v>0.353460078632996</c:v>
                </c:pt>
                <c:pt idx="52">
                  <c:v>0.353065849227975</c:v>
                </c:pt>
                <c:pt idx="53">
                  <c:v>0.353491929489222</c:v>
                </c:pt>
                <c:pt idx="54">
                  <c:v>0.35232520448349</c:v>
                </c:pt>
                <c:pt idx="55">
                  <c:v>0.354498322915079</c:v>
                </c:pt>
                <c:pt idx="56">
                  <c:v>0.353253303964758</c:v>
                </c:pt>
                <c:pt idx="57">
                  <c:v>0.35377062635975</c:v>
                </c:pt>
                <c:pt idx="58">
                  <c:v>0.353813628824881</c:v>
                </c:pt>
                <c:pt idx="59">
                  <c:v>0.3536861850906</c:v>
                </c:pt>
                <c:pt idx="60">
                  <c:v>0.353404425210289</c:v>
                </c:pt>
                <c:pt idx="61">
                  <c:v>0.353932971152527</c:v>
                </c:pt>
                <c:pt idx="62">
                  <c:v>0.354021448128993</c:v>
                </c:pt>
                <c:pt idx="63">
                  <c:v>0.354072735311157</c:v>
                </c:pt>
                <c:pt idx="64">
                  <c:v>0.353664889966601</c:v>
                </c:pt>
                <c:pt idx="65">
                  <c:v>0.353722916825494</c:v>
                </c:pt>
                <c:pt idx="66">
                  <c:v>0.353921983652556</c:v>
                </c:pt>
                <c:pt idx="67">
                  <c:v>0.355550400600518</c:v>
                </c:pt>
                <c:pt idx="68">
                  <c:v>0.354331307804021</c:v>
                </c:pt>
                <c:pt idx="69">
                  <c:v>0.354777490763594</c:v>
                </c:pt>
                <c:pt idx="70">
                  <c:v>0.355480663576931</c:v>
                </c:pt>
                <c:pt idx="71">
                  <c:v>0.354754398725939</c:v>
                </c:pt>
                <c:pt idx="72">
                  <c:v>0.352513758409601</c:v>
                </c:pt>
                <c:pt idx="73">
                  <c:v>0.354219105920381</c:v>
                </c:pt>
                <c:pt idx="74">
                  <c:v>0.354688595487621</c:v>
                </c:pt>
                <c:pt idx="75">
                  <c:v>0.354503675405286</c:v>
                </c:pt>
                <c:pt idx="76">
                  <c:v>0.354349646667379</c:v>
                </c:pt>
                <c:pt idx="77">
                  <c:v>0.355544430825801</c:v>
                </c:pt>
                <c:pt idx="78">
                  <c:v>0.355198908601081</c:v>
                </c:pt>
                <c:pt idx="79">
                  <c:v>0.35332098802941</c:v>
                </c:pt>
                <c:pt idx="80">
                  <c:v>0.354953260087833</c:v>
                </c:pt>
                <c:pt idx="81">
                  <c:v>0.355041192077215</c:v>
                </c:pt>
                <c:pt idx="82">
                  <c:v>0.353230147148243</c:v>
                </c:pt>
                <c:pt idx="83">
                  <c:v>0.354849267563983</c:v>
                </c:pt>
                <c:pt idx="84">
                  <c:v>0.354084907096009</c:v>
                </c:pt>
                <c:pt idx="85">
                  <c:v>0.353494424749265</c:v>
                </c:pt>
                <c:pt idx="86">
                  <c:v>0.353789642862545</c:v>
                </c:pt>
                <c:pt idx="87">
                  <c:v>0.352721223429167</c:v>
                </c:pt>
                <c:pt idx="88">
                  <c:v>0.353170409042143</c:v>
                </c:pt>
                <c:pt idx="89">
                  <c:v>0.352609162382824</c:v>
                </c:pt>
                <c:pt idx="90">
                  <c:v>0.352656457642767</c:v>
                </c:pt>
                <c:pt idx="91">
                  <c:v>0.352690844548055</c:v>
                </c:pt>
                <c:pt idx="92">
                  <c:v>0.353396735003797</c:v>
                </c:pt>
                <c:pt idx="93">
                  <c:v>0.353425580267863</c:v>
                </c:pt>
                <c:pt idx="94">
                  <c:v>0.355079330399964</c:v>
                </c:pt>
                <c:pt idx="95">
                  <c:v>0.354426691585933</c:v>
                </c:pt>
                <c:pt idx="96">
                  <c:v>0.35530114243822</c:v>
                </c:pt>
                <c:pt idx="97">
                  <c:v>0.355134606281779</c:v>
                </c:pt>
                <c:pt idx="98">
                  <c:v>0.354622577305462</c:v>
                </c:pt>
                <c:pt idx="99">
                  <c:v>0.354628580134065</c:v>
                </c:pt>
                <c:pt idx="100">
                  <c:v>0.35425588105425</c:v>
                </c:pt>
                <c:pt idx="101">
                  <c:v>0.354852763635255</c:v>
                </c:pt>
                <c:pt idx="102">
                  <c:v>0.354403194387375</c:v>
                </c:pt>
                <c:pt idx="103">
                  <c:v>0.354749614815493</c:v>
                </c:pt>
                <c:pt idx="104">
                  <c:v>0.355395251930576</c:v>
                </c:pt>
                <c:pt idx="105">
                  <c:v>0.354066631561274</c:v>
                </c:pt>
                <c:pt idx="106">
                  <c:v>0.355154676479138</c:v>
                </c:pt>
                <c:pt idx="107">
                  <c:v>0.355182573693716</c:v>
                </c:pt>
                <c:pt idx="108">
                  <c:v>0.355181168285037</c:v>
                </c:pt>
                <c:pt idx="109">
                  <c:v>0.355345809919001</c:v>
                </c:pt>
                <c:pt idx="110">
                  <c:v>0.355888324211624</c:v>
                </c:pt>
                <c:pt idx="111">
                  <c:v>0.355463339622352</c:v>
                </c:pt>
                <c:pt idx="112">
                  <c:v>0.355051814303408</c:v>
                </c:pt>
                <c:pt idx="113">
                  <c:v>0.355568162671364</c:v>
                </c:pt>
                <c:pt idx="114">
                  <c:v>0.355762351354665</c:v>
                </c:pt>
                <c:pt idx="115">
                  <c:v>0.355287168745876</c:v>
                </c:pt>
                <c:pt idx="116">
                  <c:v>0.356175883256528</c:v>
                </c:pt>
                <c:pt idx="117">
                  <c:v>0.354832395055685</c:v>
                </c:pt>
                <c:pt idx="118">
                  <c:v>0.355375709682369</c:v>
                </c:pt>
                <c:pt idx="119">
                  <c:v>0.355307854503075</c:v>
                </c:pt>
                <c:pt idx="120">
                  <c:v>0.356318975472308</c:v>
                </c:pt>
                <c:pt idx="121">
                  <c:v>0.356665833012697</c:v>
                </c:pt>
                <c:pt idx="122">
                  <c:v>0.355614903631693</c:v>
                </c:pt>
                <c:pt idx="123">
                  <c:v>0.356081218391158</c:v>
                </c:pt>
                <c:pt idx="124">
                  <c:v>0.356650213800105</c:v>
                </c:pt>
                <c:pt idx="125">
                  <c:v>0.356653377826415</c:v>
                </c:pt>
                <c:pt idx="126">
                  <c:v>0.357311091720591</c:v>
                </c:pt>
                <c:pt idx="127">
                  <c:v>0.357197319370756</c:v>
                </c:pt>
                <c:pt idx="128">
                  <c:v>0.357054317205708</c:v>
                </c:pt>
                <c:pt idx="129">
                  <c:v>0.355962985735367</c:v>
                </c:pt>
                <c:pt idx="130">
                  <c:v>0.357114865595133</c:v>
                </c:pt>
                <c:pt idx="131">
                  <c:v>0.356880766030876</c:v>
                </c:pt>
                <c:pt idx="132">
                  <c:v>0.357192288733479</c:v>
                </c:pt>
                <c:pt idx="133">
                  <c:v>0.357391231380798</c:v>
                </c:pt>
                <c:pt idx="134">
                  <c:v>0.356491990141713</c:v>
                </c:pt>
                <c:pt idx="135">
                  <c:v>0.357419004559858</c:v>
                </c:pt>
                <c:pt idx="136">
                  <c:v>0.358050947830658</c:v>
                </c:pt>
                <c:pt idx="137">
                  <c:v>0.357021923664593</c:v>
                </c:pt>
                <c:pt idx="138">
                  <c:v>0.357238385288805</c:v>
                </c:pt>
                <c:pt idx="139">
                  <c:v>0.358084738558556</c:v>
                </c:pt>
                <c:pt idx="140">
                  <c:v>0.35715665395129</c:v>
                </c:pt>
                <c:pt idx="141">
                  <c:v>0.35810684092143</c:v>
                </c:pt>
                <c:pt idx="142">
                  <c:v>0.357733208002599</c:v>
                </c:pt>
                <c:pt idx="143">
                  <c:v>0.35847296458873</c:v>
                </c:pt>
                <c:pt idx="144">
                  <c:v>0.357647273401756</c:v>
                </c:pt>
                <c:pt idx="145">
                  <c:v>0.357897421594149</c:v>
                </c:pt>
                <c:pt idx="146">
                  <c:v>0.357153431387696</c:v>
                </c:pt>
                <c:pt idx="147">
                  <c:v>0.35696672443406</c:v>
                </c:pt>
                <c:pt idx="148">
                  <c:v>0.357973979678632</c:v>
                </c:pt>
                <c:pt idx="149">
                  <c:v>0.357794310654368</c:v>
                </c:pt>
                <c:pt idx="150">
                  <c:v>0.357820732537277</c:v>
                </c:pt>
                <c:pt idx="151">
                  <c:v>0.357934103733478</c:v>
                </c:pt>
                <c:pt idx="152">
                  <c:v>0.35742836189594</c:v>
                </c:pt>
                <c:pt idx="153">
                  <c:v>0.357570250297605</c:v>
                </c:pt>
                <c:pt idx="154">
                  <c:v>0.358726490763537</c:v>
                </c:pt>
                <c:pt idx="155">
                  <c:v>0.35802571570207</c:v>
                </c:pt>
                <c:pt idx="156">
                  <c:v>0.358893372876619</c:v>
                </c:pt>
                <c:pt idx="157">
                  <c:v>0.357785355687435</c:v>
                </c:pt>
                <c:pt idx="158">
                  <c:v>0.358173497543055</c:v>
                </c:pt>
                <c:pt idx="159">
                  <c:v>0.358578162771958</c:v>
                </c:pt>
                <c:pt idx="160">
                  <c:v>0.357847616173808</c:v>
                </c:pt>
                <c:pt idx="161">
                  <c:v>0.359247669359851</c:v>
                </c:pt>
                <c:pt idx="162">
                  <c:v>0.358357607735577</c:v>
                </c:pt>
                <c:pt idx="163">
                  <c:v>0.358068978374348</c:v>
                </c:pt>
                <c:pt idx="164">
                  <c:v>0.357144419811248</c:v>
                </c:pt>
                <c:pt idx="165">
                  <c:v>0.356749712242361</c:v>
                </c:pt>
                <c:pt idx="166">
                  <c:v>0.357723681161659</c:v>
                </c:pt>
                <c:pt idx="167">
                  <c:v>0.357648910598169</c:v>
                </c:pt>
                <c:pt idx="168">
                  <c:v>0.357010116162782</c:v>
                </c:pt>
                <c:pt idx="169">
                  <c:v>0.357845644771106</c:v>
                </c:pt>
                <c:pt idx="170">
                  <c:v>0.35722181646928</c:v>
                </c:pt>
                <c:pt idx="171">
                  <c:v>0.357646433909064</c:v>
                </c:pt>
                <c:pt idx="172">
                  <c:v>0.357613170371283</c:v>
                </c:pt>
                <c:pt idx="173">
                  <c:v>0.356541487135295</c:v>
                </c:pt>
                <c:pt idx="174">
                  <c:v>0.357335564053537</c:v>
                </c:pt>
                <c:pt idx="175">
                  <c:v>0.358070343731189</c:v>
                </c:pt>
                <c:pt idx="176">
                  <c:v>0.356954965357968</c:v>
                </c:pt>
                <c:pt idx="177">
                  <c:v>0.356790639185376</c:v>
                </c:pt>
                <c:pt idx="178">
                  <c:v>0.356625492661831</c:v>
                </c:pt>
                <c:pt idx="179">
                  <c:v>0.356806907017383</c:v>
                </c:pt>
                <c:pt idx="180">
                  <c:v>0.357406554983478</c:v>
                </c:pt>
                <c:pt idx="181">
                  <c:v>0.357652210753351</c:v>
                </c:pt>
                <c:pt idx="182">
                  <c:v>0.357633533982371</c:v>
                </c:pt>
                <c:pt idx="183">
                  <c:v>0.357834460346132</c:v>
                </c:pt>
                <c:pt idx="184">
                  <c:v>0.358227890001697</c:v>
                </c:pt>
                <c:pt idx="185">
                  <c:v>0.357285224981142</c:v>
                </c:pt>
                <c:pt idx="186">
                  <c:v>0.358225535227115</c:v>
                </c:pt>
                <c:pt idx="187">
                  <c:v>0.35690673439946</c:v>
                </c:pt>
                <c:pt idx="188">
                  <c:v>0.356198501241303</c:v>
                </c:pt>
                <c:pt idx="189">
                  <c:v>0.357110718717921</c:v>
                </c:pt>
                <c:pt idx="190">
                  <c:v>0.356073988563041</c:v>
                </c:pt>
                <c:pt idx="191">
                  <c:v>0.356834017995371</c:v>
                </c:pt>
                <c:pt idx="192">
                  <c:v>0.356144643757544</c:v>
                </c:pt>
                <c:pt idx="193">
                  <c:v>0.356966454358943</c:v>
                </c:pt>
                <c:pt idx="194">
                  <c:v>0.357082500882321</c:v>
                </c:pt>
                <c:pt idx="195">
                  <c:v>0.35647522532862</c:v>
                </c:pt>
                <c:pt idx="196">
                  <c:v>0.356816236179291</c:v>
                </c:pt>
                <c:pt idx="197">
                  <c:v>0.35533754099611</c:v>
                </c:pt>
                <c:pt idx="198">
                  <c:v>0.356418836140888</c:v>
                </c:pt>
                <c:pt idx="199">
                  <c:v>0.356201030297472</c:v>
                </c:pt>
                <c:pt idx="200">
                  <c:v>0.356454167496133</c:v>
                </c:pt>
              </c:numCache>
            </c:numRef>
          </c:val>
          <c:smooth val="0"/>
        </c:ser>
        <c:ser>
          <c:idx val="1"/>
          <c:order val="1"/>
          <c:tx>
            <c:v>with AO pretreatment</c:v>
          </c:tx>
          <c:spPr>
            <a:ln>
              <a:solidFill>
                <a:schemeClr val="bg1"/>
              </a:solidFill>
            </a:ln>
          </c:spPr>
          <c:marker>
            <c:symbol val="none"/>
          </c:marker>
          <c:trendline>
            <c:spPr>
              <a:ln w="12700">
                <a:solidFill>
                  <a:schemeClr val="bg1">
                    <a:lumMod val="50000"/>
                  </a:schemeClr>
                </a:solidFill>
              </a:ln>
            </c:spPr>
            <c:trendlineType val="movingAvg"/>
            <c:period val="6"/>
            <c:dispRSqr val="0"/>
            <c:dispEq val="0"/>
          </c:trendline>
          <c:cat>
            <c:numRef>
              <c:f>Feuil2!$A$1:$A$201</c:f>
              <c:numCache>
                <c:formatCode>General</c:formatCode>
                <c:ptCount val="201"/>
                <c:pt idx="0">
                  <c:v>0.0</c:v>
                </c:pt>
                <c:pt idx="1">
                  <c:v>5.0</c:v>
                </c:pt>
                <c:pt idx="2">
                  <c:v>10.0</c:v>
                </c:pt>
                <c:pt idx="3">
                  <c:v>15.0</c:v>
                </c:pt>
                <c:pt idx="4">
                  <c:v>20.0</c:v>
                </c:pt>
                <c:pt idx="5">
                  <c:v>25.0</c:v>
                </c:pt>
                <c:pt idx="6">
                  <c:v>30.0</c:v>
                </c:pt>
                <c:pt idx="7">
                  <c:v>35.0</c:v>
                </c:pt>
                <c:pt idx="8">
                  <c:v>40.0</c:v>
                </c:pt>
                <c:pt idx="9">
                  <c:v>45.0</c:v>
                </c:pt>
                <c:pt idx="10">
                  <c:v>50.0</c:v>
                </c:pt>
                <c:pt idx="11">
                  <c:v>55.0</c:v>
                </c:pt>
                <c:pt idx="12">
                  <c:v>60.0</c:v>
                </c:pt>
                <c:pt idx="13">
                  <c:v>65.0</c:v>
                </c:pt>
                <c:pt idx="14">
                  <c:v>70.0</c:v>
                </c:pt>
                <c:pt idx="15">
                  <c:v>75.0</c:v>
                </c:pt>
                <c:pt idx="16">
                  <c:v>80.0</c:v>
                </c:pt>
                <c:pt idx="17">
                  <c:v>85.0</c:v>
                </c:pt>
                <c:pt idx="18">
                  <c:v>90.0</c:v>
                </c:pt>
                <c:pt idx="19">
                  <c:v>95.0</c:v>
                </c:pt>
                <c:pt idx="20">
                  <c:v>100.0</c:v>
                </c:pt>
                <c:pt idx="21">
                  <c:v>105.0</c:v>
                </c:pt>
                <c:pt idx="22">
                  <c:v>110.0</c:v>
                </c:pt>
                <c:pt idx="23">
                  <c:v>115.0</c:v>
                </c:pt>
                <c:pt idx="24">
                  <c:v>120.0</c:v>
                </c:pt>
                <c:pt idx="25">
                  <c:v>125.0</c:v>
                </c:pt>
                <c:pt idx="26">
                  <c:v>130.0</c:v>
                </c:pt>
                <c:pt idx="27">
                  <c:v>135.0</c:v>
                </c:pt>
                <c:pt idx="28">
                  <c:v>140.0</c:v>
                </c:pt>
                <c:pt idx="29">
                  <c:v>145.0</c:v>
                </c:pt>
                <c:pt idx="30">
                  <c:v>150.0</c:v>
                </c:pt>
                <c:pt idx="31">
                  <c:v>155.0</c:v>
                </c:pt>
                <c:pt idx="32">
                  <c:v>160.0</c:v>
                </c:pt>
                <c:pt idx="33">
                  <c:v>165.0</c:v>
                </c:pt>
                <c:pt idx="34">
                  <c:v>170.0</c:v>
                </c:pt>
                <c:pt idx="35">
                  <c:v>175.0</c:v>
                </c:pt>
                <c:pt idx="36">
                  <c:v>180.0</c:v>
                </c:pt>
                <c:pt idx="37">
                  <c:v>185.0</c:v>
                </c:pt>
                <c:pt idx="38">
                  <c:v>190.0</c:v>
                </c:pt>
                <c:pt idx="39">
                  <c:v>195.0</c:v>
                </c:pt>
                <c:pt idx="40">
                  <c:v>200.0</c:v>
                </c:pt>
                <c:pt idx="41">
                  <c:v>205.0</c:v>
                </c:pt>
                <c:pt idx="42">
                  <c:v>210.0</c:v>
                </c:pt>
                <c:pt idx="43">
                  <c:v>215.0</c:v>
                </c:pt>
                <c:pt idx="44">
                  <c:v>220.0</c:v>
                </c:pt>
                <c:pt idx="45">
                  <c:v>225.0</c:v>
                </c:pt>
                <c:pt idx="46">
                  <c:v>230.0</c:v>
                </c:pt>
                <c:pt idx="47">
                  <c:v>235.0</c:v>
                </c:pt>
                <c:pt idx="48">
                  <c:v>240.0</c:v>
                </c:pt>
                <c:pt idx="49">
                  <c:v>245.0</c:v>
                </c:pt>
                <c:pt idx="50">
                  <c:v>250.0</c:v>
                </c:pt>
                <c:pt idx="51">
                  <c:v>255.0</c:v>
                </c:pt>
                <c:pt idx="52">
                  <c:v>260.0</c:v>
                </c:pt>
                <c:pt idx="53">
                  <c:v>265.0</c:v>
                </c:pt>
                <c:pt idx="54">
                  <c:v>270.0</c:v>
                </c:pt>
                <c:pt idx="55">
                  <c:v>275.0</c:v>
                </c:pt>
                <c:pt idx="56">
                  <c:v>280.0</c:v>
                </c:pt>
                <c:pt idx="57">
                  <c:v>285.0</c:v>
                </c:pt>
                <c:pt idx="58">
                  <c:v>290.0</c:v>
                </c:pt>
                <c:pt idx="59">
                  <c:v>295.0</c:v>
                </c:pt>
                <c:pt idx="60">
                  <c:v>300.0</c:v>
                </c:pt>
                <c:pt idx="61">
                  <c:v>305.0</c:v>
                </c:pt>
                <c:pt idx="62">
                  <c:v>310.0</c:v>
                </c:pt>
                <c:pt idx="63">
                  <c:v>315.0</c:v>
                </c:pt>
                <c:pt idx="64">
                  <c:v>320.0</c:v>
                </c:pt>
                <c:pt idx="65">
                  <c:v>325.0</c:v>
                </c:pt>
                <c:pt idx="66">
                  <c:v>330.0</c:v>
                </c:pt>
                <c:pt idx="67">
                  <c:v>335.0</c:v>
                </c:pt>
                <c:pt idx="68">
                  <c:v>340.0</c:v>
                </c:pt>
                <c:pt idx="69">
                  <c:v>345.0</c:v>
                </c:pt>
                <c:pt idx="70">
                  <c:v>350.0</c:v>
                </c:pt>
                <c:pt idx="71">
                  <c:v>355.0</c:v>
                </c:pt>
                <c:pt idx="72">
                  <c:v>360.0</c:v>
                </c:pt>
                <c:pt idx="73">
                  <c:v>365.0</c:v>
                </c:pt>
                <c:pt idx="74">
                  <c:v>370.0</c:v>
                </c:pt>
                <c:pt idx="75">
                  <c:v>375.0</c:v>
                </c:pt>
                <c:pt idx="76">
                  <c:v>380.0</c:v>
                </c:pt>
                <c:pt idx="77">
                  <c:v>385.0</c:v>
                </c:pt>
                <c:pt idx="78">
                  <c:v>390.0</c:v>
                </c:pt>
                <c:pt idx="79">
                  <c:v>395.0</c:v>
                </c:pt>
                <c:pt idx="80">
                  <c:v>400.0</c:v>
                </c:pt>
                <c:pt idx="81">
                  <c:v>405.0</c:v>
                </c:pt>
                <c:pt idx="82">
                  <c:v>410.0</c:v>
                </c:pt>
                <c:pt idx="83">
                  <c:v>415.0</c:v>
                </c:pt>
                <c:pt idx="84">
                  <c:v>420.0</c:v>
                </c:pt>
                <c:pt idx="85">
                  <c:v>425.0</c:v>
                </c:pt>
                <c:pt idx="86">
                  <c:v>430.0</c:v>
                </c:pt>
                <c:pt idx="87">
                  <c:v>435.0</c:v>
                </c:pt>
                <c:pt idx="88">
                  <c:v>440.0</c:v>
                </c:pt>
                <c:pt idx="89">
                  <c:v>445.0</c:v>
                </c:pt>
                <c:pt idx="90">
                  <c:v>450.0</c:v>
                </c:pt>
                <c:pt idx="91">
                  <c:v>455.0</c:v>
                </c:pt>
                <c:pt idx="92">
                  <c:v>460.0</c:v>
                </c:pt>
                <c:pt idx="93">
                  <c:v>465.0</c:v>
                </c:pt>
                <c:pt idx="94">
                  <c:v>470.0</c:v>
                </c:pt>
                <c:pt idx="95">
                  <c:v>475.0</c:v>
                </c:pt>
                <c:pt idx="96">
                  <c:v>480.0</c:v>
                </c:pt>
                <c:pt idx="97">
                  <c:v>485.0</c:v>
                </c:pt>
                <c:pt idx="98">
                  <c:v>490.0</c:v>
                </c:pt>
                <c:pt idx="99">
                  <c:v>495.0</c:v>
                </c:pt>
                <c:pt idx="100">
                  <c:v>500.0</c:v>
                </c:pt>
                <c:pt idx="101">
                  <c:v>505.0</c:v>
                </c:pt>
                <c:pt idx="102">
                  <c:v>510.0</c:v>
                </c:pt>
                <c:pt idx="103">
                  <c:v>515.0</c:v>
                </c:pt>
                <c:pt idx="104">
                  <c:v>520.0</c:v>
                </c:pt>
                <c:pt idx="105">
                  <c:v>525.0</c:v>
                </c:pt>
                <c:pt idx="106">
                  <c:v>530.0</c:v>
                </c:pt>
                <c:pt idx="107">
                  <c:v>535.0</c:v>
                </c:pt>
                <c:pt idx="108">
                  <c:v>540.0</c:v>
                </c:pt>
                <c:pt idx="109">
                  <c:v>545.0</c:v>
                </c:pt>
                <c:pt idx="110">
                  <c:v>550.0</c:v>
                </c:pt>
                <c:pt idx="111">
                  <c:v>555.0</c:v>
                </c:pt>
                <c:pt idx="112">
                  <c:v>560.0</c:v>
                </c:pt>
                <c:pt idx="113">
                  <c:v>565.0</c:v>
                </c:pt>
                <c:pt idx="114">
                  <c:v>570.0</c:v>
                </c:pt>
                <c:pt idx="115">
                  <c:v>575.0</c:v>
                </c:pt>
                <c:pt idx="116">
                  <c:v>580.0</c:v>
                </c:pt>
                <c:pt idx="117">
                  <c:v>585.0</c:v>
                </c:pt>
                <c:pt idx="118">
                  <c:v>590.0</c:v>
                </c:pt>
                <c:pt idx="119">
                  <c:v>595.0</c:v>
                </c:pt>
                <c:pt idx="120">
                  <c:v>600.0</c:v>
                </c:pt>
                <c:pt idx="121">
                  <c:v>605.0</c:v>
                </c:pt>
                <c:pt idx="122">
                  <c:v>610.0</c:v>
                </c:pt>
                <c:pt idx="123">
                  <c:v>615.0</c:v>
                </c:pt>
                <c:pt idx="124">
                  <c:v>620.0</c:v>
                </c:pt>
                <c:pt idx="125">
                  <c:v>625.0</c:v>
                </c:pt>
                <c:pt idx="126">
                  <c:v>630.0</c:v>
                </c:pt>
                <c:pt idx="127">
                  <c:v>635.0</c:v>
                </c:pt>
                <c:pt idx="128">
                  <c:v>640.0</c:v>
                </c:pt>
                <c:pt idx="129">
                  <c:v>645.0</c:v>
                </c:pt>
                <c:pt idx="130">
                  <c:v>650.0</c:v>
                </c:pt>
                <c:pt idx="131">
                  <c:v>655.0</c:v>
                </c:pt>
                <c:pt idx="132">
                  <c:v>660.0</c:v>
                </c:pt>
                <c:pt idx="133">
                  <c:v>665.0</c:v>
                </c:pt>
                <c:pt idx="134">
                  <c:v>670.0</c:v>
                </c:pt>
                <c:pt idx="135">
                  <c:v>675.0</c:v>
                </c:pt>
                <c:pt idx="136">
                  <c:v>680.0</c:v>
                </c:pt>
                <c:pt idx="137">
                  <c:v>685.0</c:v>
                </c:pt>
                <c:pt idx="138">
                  <c:v>690.0</c:v>
                </c:pt>
                <c:pt idx="139">
                  <c:v>695.0</c:v>
                </c:pt>
                <c:pt idx="140">
                  <c:v>700.0</c:v>
                </c:pt>
                <c:pt idx="141">
                  <c:v>705.0</c:v>
                </c:pt>
                <c:pt idx="142">
                  <c:v>710.0</c:v>
                </c:pt>
                <c:pt idx="143">
                  <c:v>715.0</c:v>
                </c:pt>
                <c:pt idx="144">
                  <c:v>720.0</c:v>
                </c:pt>
                <c:pt idx="145">
                  <c:v>725.0</c:v>
                </c:pt>
                <c:pt idx="146">
                  <c:v>730.0</c:v>
                </c:pt>
                <c:pt idx="147">
                  <c:v>735.0</c:v>
                </c:pt>
                <c:pt idx="148">
                  <c:v>740.0</c:v>
                </c:pt>
                <c:pt idx="149">
                  <c:v>745.0</c:v>
                </c:pt>
                <c:pt idx="150">
                  <c:v>750.0</c:v>
                </c:pt>
                <c:pt idx="151">
                  <c:v>755.0</c:v>
                </c:pt>
                <c:pt idx="152">
                  <c:v>760.0</c:v>
                </c:pt>
                <c:pt idx="153">
                  <c:v>765.0</c:v>
                </c:pt>
                <c:pt idx="154">
                  <c:v>770.0</c:v>
                </c:pt>
                <c:pt idx="155">
                  <c:v>775.0</c:v>
                </c:pt>
                <c:pt idx="156">
                  <c:v>780.0</c:v>
                </c:pt>
                <c:pt idx="157">
                  <c:v>785.0</c:v>
                </c:pt>
                <c:pt idx="158">
                  <c:v>790.0</c:v>
                </c:pt>
                <c:pt idx="159">
                  <c:v>795.0</c:v>
                </c:pt>
                <c:pt idx="160">
                  <c:v>800.0</c:v>
                </c:pt>
                <c:pt idx="161">
                  <c:v>805.0</c:v>
                </c:pt>
                <c:pt idx="162">
                  <c:v>810.0</c:v>
                </c:pt>
                <c:pt idx="163">
                  <c:v>815.0</c:v>
                </c:pt>
                <c:pt idx="164">
                  <c:v>820.0</c:v>
                </c:pt>
                <c:pt idx="165">
                  <c:v>825.0</c:v>
                </c:pt>
                <c:pt idx="166">
                  <c:v>830.0</c:v>
                </c:pt>
                <c:pt idx="167">
                  <c:v>835.0</c:v>
                </c:pt>
                <c:pt idx="168">
                  <c:v>840.0</c:v>
                </c:pt>
                <c:pt idx="169">
                  <c:v>845.0</c:v>
                </c:pt>
                <c:pt idx="170">
                  <c:v>850.0</c:v>
                </c:pt>
                <c:pt idx="171">
                  <c:v>855.0</c:v>
                </c:pt>
                <c:pt idx="172">
                  <c:v>860.0</c:v>
                </c:pt>
                <c:pt idx="173">
                  <c:v>865.0</c:v>
                </c:pt>
                <c:pt idx="174">
                  <c:v>870.0</c:v>
                </c:pt>
                <c:pt idx="175">
                  <c:v>875.0</c:v>
                </c:pt>
                <c:pt idx="176">
                  <c:v>880.0</c:v>
                </c:pt>
                <c:pt idx="177">
                  <c:v>885.0</c:v>
                </c:pt>
                <c:pt idx="178">
                  <c:v>890.0</c:v>
                </c:pt>
                <c:pt idx="179">
                  <c:v>895.0</c:v>
                </c:pt>
                <c:pt idx="180">
                  <c:v>900.0</c:v>
                </c:pt>
                <c:pt idx="181">
                  <c:v>905.0</c:v>
                </c:pt>
                <c:pt idx="182">
                  <c:v>910.0</c:v>
                </c:pt>
                <c:pt idx="183">
                  <c:v>915.0</c:v>
                </c:pt>
                <c:pt idx="184">
                  <c:v>920.0</c:v>
                </c:pt>
                <c:pt idx="185">
                  <c:v>925.0</c:v>
                </c:pt>
                <c:pt idx="186">
                  <c:v>930.0</c:v>
                </c:pt>
                <c:pt idx="187">
                  <c:v>935.0</c:v>
                </c:pt>
                <c:pt idx="188">
                  <c:v>940.0</c:v>
                </c:pt>
                <c:pt idx="189">
                  <c:v>945.0</c:v>
                </c:pt>
                <c:pt idx="190">
                  <c:v>950.0</c:v>
                </c:pt>
                <c:pt idx="191">
                  <c:v>955.0</c:v>
                </c:pt>
                <c:pt idx="192">
                  <c:v>960.0</c:v>
                </c:pt>
                <c:pt idx="193">
                  <c:v>965.0</c:v>
                </c:pt>
                <c:pt idx="194">
                  <c:v>970.0</c:v>
                </c:pt>
                <c:pt idx="195">
                  <c:v>975.0</c:v>
                </c:pt>
                <c:pt idx="196">
                  <c:v>980.0</c:v>
                </c:pt>
                <c:pt idx="197">
                  <c:v>985.0</c:v>
                </c:pt>
                <c:pt idx="198">
                  <c:v>990.0</c:v>
                </c:pt>
                <c:pt idx="199">
                  <c:v>995.0</c:v>
                </c:pt>
                <c:pt idx="200">
                  <c:v>1000.0</c:v>
                </c:pt>
              </c:numCache>
            </c:numRef>
          </c:cat>
          <c:val>
            <c:numRef>
              <c:f>Feuil2!$C$1:$C$201</c:f>
              <c:numCache>
                <c:formatCode>General</c:formatCode>
                <c:ptCount val="201"/>
                <c:pt idx="0">
                  <c:v>0.344847777382313</c:v>
                </c:pt>
                <c:pt idx="1">
                  <c:v>0.346628803074328</c:v>
                </c:pt>
                <c:pt idx="2">
                  <c:v>0.344230941597845</c:v>
                </c:pt>
                <c:pt idx="3">
                  <c:v>0.343922517878669</c:v>
                </c:pt>
                <c:pt idx="4">
                  <c:v>0.3446381812382</c:v>
                </c:pt>
                <c:pt idx="5">
                  <c:v>0.343894521036898</c:v>
                </c:pt>
                <c:pt idx="6">
                  <c:v>0.343510915914363</c:v>
                </c:pt>
                <c:pt idx="7">
                  <c:v>0.344445324161613</c:v>
                </c:pt>
                <c:pt idx="8">
                  <c:v>0.34572833328372</c:v>
                </c:pt>
                <c:pt idx="9">
                  <c:v>0.344632913714079</c:v>
                </c:pt>
                <c:pt idx="10">
                  <c:v>0.345796420901933</c:v>
                </c:pt>
                <c:pt idx="11">
                  <c:v>0.344592775735908</c:v>
                </c:pt>
                <c:pt idx="12">
                  <c:v>0.346001805926301</c:v>
                </c:pt>
                <c:pt idx="13">
                  <c:v>0.34461379625298</c:v>
                </c:pt>
                <c:pt idx="14">
                  <c:v>0.344614487430779</c:v>
                </c:pt>
                <c:pt idx="15">
                  <c:v>0.347311072661672</c:v>
                </c:pt>
                <c:pt idx="16">
                  <c:v>0.346065467542727</c:v>
                </c:pt>
                <c:pt idx="17">
                  <c:v>0.346227840832189</c:v>
                </c:pt>
                <c:pt idx="18">
                  <c:v>0.345484247232659</c:v>
                </c:pt>
                <c:pt idx="19">
                  <c:v>0.345312506435144</c:v>
                </c:pt>
                <c:pt idx="20">
                  <c:v>0.346848398347582</c:v>
                </c:pt>
                <c:pt idx="21">
                  <c:v>0.345781614115441</c:v>
                </c:pt>
                <c:pt idx="22">
                  <c:v>0.345857331227067</c:v>
                </c:pt>
                <c:pt idx="23">
                  <c:v>0.345755285423583</c:v>
                </c:pt>
                <c:pt idx="24">
                  <c:v>0.346429523751013</c:v>
                </c:pt>
                <c:pt idx="25">
                  <c:v>0.346838015295367</c:v>
                </c:pt>
                <c:pt idx="26">
                  <c:v>0.345670268468206</c:v>
                </c:pt>
                <c:pt idx="27">
                  <c:v>0.346498461497103</c:v>
                </c:pt>
                <c:pt idx="28">
                  <c:v>0.346629671680315</c:v>
                </c:pt>
                <c:pt idx="29">
                  <c:v>0.347488267551439</c:v>
                </c:pt>
                <c:pt idx="30">
                  <c:v>0.346318789079428</c:v>
                </c:pt>
                <c:pt idx="31">
                  <c:v>0.346545584811519</c:v>
                </c:pt>
                <c:pt idx="32">
                  <c:v>0.347509027664166</c:v>
                </c:pt>
                <c:pt idx="33">
                  <c:v>0.34708299211617</c:v>
                </c:pt>
                <c:pt idx="34">
                  <c:v>0.348019807216116</c:v>
                </c:pt>
                <c:pt idx="35">
                  <c:v>0.348130759921138</c:v>
                </c:pt>
                <c:pt idx="36">
                  <c:v>0.348081525488693</c:v>
                </c:pt>
                <c:pt idx="37">
                  <c:v>0.348118125048786</c:v>
                </c:pt>
                <c:pt idx="38">
                  <c:v>0.34893131630155</c:v>
                </c:pt>
                <c:pt idx="39">
                  <c:v>0.34830364979259</c:v>
                </c:pt>
                <c:pt idx="40">
                  <c:v>0.348987502940392</c:v>
                </c:pt>
                <c:pt idx="41">
                  <c:v>0.348715452410315</c:v>
                </c:pt>
                <c:pt idx="42">
                  <c:v>0.348114559530207</c:v>
                </c:pt>
                <c:pt idx="43">
                  <c:v>0.348516503812128</c:v>
                </c:pt>
                <c:pt idx="44">
                  <c:v>0.348158115158783</c:v>
                </c:pt>
                <c:pt idx="45">
                  <c:v>0.345530199416982</c:v>
                </c:pt>
                <c:pt idx="46">
                  <c:v>0.348121227750417</c:v>
                </c:pt>
                <c:pt idx="47">
                  <c:v>0.347692394925804</c:v>
                </c:pt>
                <c:pt idx="48">
                  <c:v>0.347740748480607</c:v>
                </c:pt>
                <c:pt idx="49">
                  <c:v>0.347201494449993</c:v>
                </c:pt>
                <c:pt idx="50">
                  <c:v>0.346103909901292</c:v>
                </c:pt>
                <c:pt idx="51">
                  <c:v>0.346716097443027</c:v>
                </c:pt>
                <c:pt idx="52">
                  <c:v>0.346836408922407</c:v>
                </c:pt>
                <c:pt idx="53">
                  <c:v>0.346643777575042</c:v>
                </c:pt>
                <c:pt idx="54">
                  <c:v>0.347585432442081</c:v>
                </c:pt>
                <c:pt idx="55">
                  <c:v>0.345938863379949</c:v>
                </c:pt>
                <c:pt idx="56">
                  <c:v>0.347041930641045</c:v>
                </c:pt>
                <c:pt idx="57">
                  <c:v>0.347589300961014</c:v>
                </c:pt>
                <c:pt idx="58">
                  <c:v>0.346203966769884</c:v>
                </c:pt>
                <c:pt idx="59">
                  <c:v>0.348082862409023</c:v>
                </c:pt>
                <c:pt idx="60">
                  <c:v>0.347525240937589</c:v>
                </c:pt>
                <c:pt idx="61">
                  <c:v>0.347472614843645</c:v>
                </c:pt>
                <c:pt idx="62">
                  <c:v>0.348214241845486</c:v>
                </c:pt>
                <c:pt idx="63">
                  <c:v>0.348703372817908</c:v>
                </c:pt>
                <c:pt idx="64">
                  <c:v>0.347342485732404</c:v>
                </c:pt>
                <c:pt idx="65">
                  <c:v>0.347439780161097</c:v>
                </c:pt>
                <c:pt idx="66">
                  <c:v>0.34789490278488</c:v>
                </c:pt>
                <c:pt idx="67">
                  <c:v>0.34835703585164</c:v>
                </c:pt>
                <c:pt idx="68">
                  <c:v>0.34714025439581</c:v>
                </c:pt>
                <c:pt idx="69">
                  <c:v>0.348623115161558</c:v>
                </c:pt>
                <c:pt idx="70">
                  <c:v>0.348178341124296</c:v>
                </c:pt>
                <c:pt idx="71">
                  <c:v>0.348497268019783</c:v>
                </c:pt>
                <c:pt idx="72">
                  <c:v>0.349502647424508</c:v>
                </c:pt>
                <c:pt idx="73">
                  <c:v>0.34775315476146</c:v>
                </c:pt>
                <c:pt idx="74">
                  <c:v>0.349450208633469</c:v>
                </c:pt>
                <c:pt idx="75">
                  <c:v>0.347377420215526</c:v>
                </c:pt>
                <c:pt idx="76">
                  <c:v>0.347498664933838</c:v>
                </c:pt>
                <c:pt idx="77">
                  <c:v>0.348424265098878</c:v>
                </c:pt>
                <c:pt idx="78">
                  <c:v>0.347846633083932</c:v>
                </c:pt>
                <c:pt idx="79">
                  <c:v>0.349059776536313</c:v>
                </c:pt>
                <c:pt idx="80">
                  <c:v>0.347890516125692</c:v>
                </c:pt>
                <c:pt idx="81">
                  <c:v>0.349303355405767</c:v>
                </c:pt>
                <c:pt idx="82">
                  <c:v>0.347607816395366</c:v>
                </c:pt>
                <c:pt idx="83">
                  <c:v>0.347689730379779</c:v>
                </c:pt>
                <c:pt idx="84">
                  <c:v>0.347735280558957</c:v>
                </c:pt>
                <c:pt idx="85">
                  <c:v>0.346936901506133</c:v>
                </c:pt>
                <c:pt idx="86">
                  <c:v>0.347703716101559</c:v>
                </c:pt>
                <c:pt idx="87">
                  <c:v>0.34733934250008</c:v>
                </c:pt>
                <c:pt idx="88">
                  <c:v>0.346908351164121</c:v>
                </c:pt>
                <c:pt idx="89">
                  <c:v>0.347053934784379</c:v>
                </c:pt>
                <c:pt idx="90">
                  <c:v>0.34599288679453</c:v>
                </c:pt>
                <c:pt idx="91">
                  <c:v>0.34700323312092</c:v>
                </c:pt>
                <c:pt idx="92">
                  <c:v>0.34538022666269</c:v>
                </c:pt>
                <c:pt idx="93">
                  <c:v>0.344394198917262</c:v>
                </c:pt>
                <c:pt idx="94">
                  <c:v>0.34648921247872</c:v>
                </c:pt>
                <c:pt idx="95">
                  <c:v>0.345932736872983</c:v>
                </c:pt>
                <c:pt idx="96">
                  <c:v>0.346331173063888</c:v>
                </c:pt>
                <c:pt idx="97">
                  <c:v>0.346188878706922</c:v>
                </c:pt>
                <c:pt idx="98">
                  <c:v>0.345558830268378</c:v>
                </c:pt>
                <c:pt idx="99">
                  <c:v>0.345261069956837</c:v>
                </c:pt>
                <c:pt idx="100">
                  <c:v>0.346338306202713</c:v>
                </c:pt>
                <c:pt idx="101">
                  <c:v>0.346638963864372</c:v>
                </c:pt>
                <c:pt idx="102">
                  <c:v>0.34638016638841</c:v>
                </c:pt>
                <c:pt idx="103">
                  <c:v>0.346653432725804</c:v>
                </c:pt>
                <c:pt idx="104">
                  <c:v>0.346494887332747</c:v>
                </c:pt>
                <c:pt idx="105">
                  <c:v>0.345685921346929</c:v>
                </c:pt>
                <c:pt idx="106">
                  <c:v>0.347344487041537</c:v>
                </c:pt>
                <c:pt idx="107">
                  <c:v>0.347091306671417</c:v>
                </c:pt>
                <c:pt idx="108">
                  <c:v>0.346099706179089</c:v>
                </c:pt>
                <c:pt idx="109">
                  <c:v>0.346456986936606</c:v>
                </c:pt>
                <c:pt idx="110">
                  <c:v>0.346043395905585</c:v>
                </c:pt>
                <c:pt idx="111">
                  <c:v>0.345200072733435</c:v>
                </c:pt>
                <c:pt idx="112">
                  <c:v>0.346295970388675</c:v>
                </c:pt>
                <c:pt idx="113">
                  <c:v>0.346452052499302</c:v>
                </c:pt>
                <c:pt idx="114">
                  <c:v>0.346981927240264</c:v>
                </c:pt>
                <c:pt idx="115">
                  <c:v>0.344444385453813</c:v>
                </c:pt>
                <c:pt idx="116">
                  <c:v>0.345719941460711</c:v>
                </c:pt>
                <c:pt idx="117">
                  <c:v>0.344610693041915</c:v>
                </c:pt>
                <c:pt idx="118">
                  <c:v>0.345620938357874</c:v>
                </c:pt>
                <c:pt idx="119">
                  <c:v>0.344850400298025</c:v>
                </c:pt>
                <c:pt idx="120">
                  <c:v>0.345057934038581</c:v>
                </c:pt>
                <c:pt idx="121">
                  <c:v>0.345444503708729</c:v>
                </c:pt>
                <c:pt idx="122">
                  <c:v>0.344223572348648</c:v>
                </c:pt>
                <c:pt idx="123">
                  <c:v>0.34393876894304</c:v>
                </c:pt>
                <c:pt idx="124">
                  <c:v>0.34393308309924</c:v>
                </c:pt>
                <c:pt idx="125">
                  <c:v>0.344912142616191</c:v>
                </c:pt>
                <c:pt idx="126">
                  <c:v>0.344103341791677</c:v>
                </c:pt>
                <c:pt idx="127">
                  <c:v>0.344548281864083</c:v>
                </c:pt>
                <c:pt idx="128">
                  <c:v>0.345559831295454</c:v>
                </c:pt>
                <c:pt idx="129">
                  <c:v>0.346144161233983</c:v>
                </c:pt>
                <c:pt idx="130">
                  <c:v>0.345122722943332</c:v>
                </c:pt>
                <c:pt idx="131">
                  <c:v>0.345994102524695</c:v>
                </c:pt>
                <c:pt idx="132">
                  <c:v>0.345728244918437</c:v>
                </c:pt>
                <c:pt idx="133">
                  <c:v>0.347094847557104</c:v>
                </c:pt>
                <c:pt idx="134">
                  <c:v>0.347591754981675</c:v>
                </c:pt>
                <c:pt idx="135">
                  <c:v>0.346141133079281</c:v>
                </c:pt>
                <c:pt idx="136">
                  <c:v>0.346729493699346</c:v>
                </c:pt>
                <c:pt idx="137">
                  <c:v>0.346450538939687</c:v>
                </c:pt>
                <c:pt idx="138">
                  <c:v>0.346593375597932</c:v>
                </c:pt>
                <c:pt idx="139">
                  <c:v>0.347810319010066</c:v>
                </c:pt>
                <c:pt idx="140">
                  <c:v>0.347998769316251</c:v>
                </c:pt>
                <c:pt idx="141">
                  <c:v>0.348214045083878</c:v>
                </c:pt>
                <c:pt idx="142">
                  <c:v>0.347462765911481</c:v>
                </c:pt>
                <c:pt idx="143">
                  <c:v>0.34786534906191</c:v>
                </c:pt>
                <c:pt idx="144">
                  <c:v>0.347422186959031</c:v>
                </c:pt>
                <c:pt idx="145">
                  <c:v>0.347645632538305</c:v>
                </c:pt>
                <c:pt idx="146">
                  <c:v>0.348963901469889</c:v>
                </c:pt>
                <c:pt idx="147">
                  <c:v>0.347357463247714</c:v>
                </c:pt>
                <c:pt idx="148">
                  <c:v>0.347526008433015</c:v>
                </c:pt>
                <c:pt idx="149">
                  <c:v>0.347229610888907</c:v>
                </c:pt>
                <c:pt idx="150">
                  <c:v>0.347846166786138</c:v>
                </c:pt>
                <c:pt idx="151">
                  <c:v>0.347214321819109</c:v>
                </c:pt>
                <c:pt idx="152">
                  <c:v>0.347525948204445</c:v>
                </c:pt>
                <c:pt idx="153">
                  <c:v>0.347532961120111</c:v>
                </c:pt>
                <c:pt idx="154">
                  <c:v>0.348824308658637</c:v>
                </c:pt>
                <c:pt idx="155">
                  <c:v>0.34763224767436</c:v>
                </c:pt>
                <c:pt idx="156">
                  <c:v>0.348399675052028</c:v>
                </c:pt>
                <c:pt idx="157">
                  <c:v>0.347588948362143</c:v>
                </c:pt>
                <c:pt idx="158">
                  <c:v>0.348014126014018</c:v>
                </c:pt>
                <c:pt idx="159">
                  <c:v>0.348408499095841</c:v>
                </c:pt>
                <c:pt idx="160">
                  <c:v>0.348575137121728</c:v>
                </c:pt>
                <c:pt idx="161">
                  <c:v>0.348312561456085</c:v>
                </c:pt>
                <c:pt idx="162">
                  <c:v>0.34914295542019</c:v>
                </c:pt>
                <c:pt idx="163">
                  <c:v>0.348724936522581</c:v>
                </c:pt>
                <c:pt idx="164">
                  <c:v>0.3492958977717</c:v>
                </c:pt>
                <c:pt idx="165">
                  <c:v>0.348574970749847</c:v>
                </c:pt>
                <c:pt idx="166">
                  <c:v>0.349061790910814</c:v>
                </c:pt>
                <c:pt idx="167">
                  <c:v>0.348714071653204</c:v>
                </c:pt>
                <c:pt idx="168">
                  <c:v>0.350238927747961</c:v>
                </c:pt>
                <c:pt idx="169">
                  <c:v>0.349149837577282</c:v>
                </c:pt>
                <c:pt idx="170">
                  <c:v>0.349221011985667</c:v>
                </c:pt>
                <c:pt idx="171">
                  <c:v>0.349252593207003</c:v>
                </c:pt>
                <c:pt idx="172">
                  <c:v>0.349929064713614</c:v>
                </c:pt>
                <c:pt idx="173">
                  <c:v>0.34978688271903</c:v>
                </c:pt>
                <c:pt idx="174">
                  <c:v>0.349160849559857</c:v>
                </c:pt>
                <c:pt idx="175">
                  <c:v>0.350515274274474</c:v>
                </c:pt>
                <c:pt idx="176">
                  <c:v>0.351212160192836</c:v>
                </c:pt>
                <c:pt idx="177">
                  <c:v>0.350718353035464</c:v>
                </c:pt>
                <c:pt idx="178">
                  <c:v>0.350323482103159</c:v>
                </c:pt>
                <c:pt idx="179">
                  <c:v>0.351167671757988</c:v>
                </c:pt>
                <c:pt idx="180">
                  <c:v>0.35065790836056</c:v>
                </c:pt>
                <c:pt idx="181">
                  <c:v>0.351371470084727</c:v>
                </c:pt>
                <c:pt idx="182">
                  <c:v>0.351874211859469</c:v>
                </c:pt>
                <c:pt idx="183">
                  <c:v>0.350427735348819</c:v>
                </c:pt>
                <c:pt idx="184">
                  <c:v>0.35045649230527</c:v>
                </c:pt>
                <c:pt idx="185">
                  <c:v>0.351419319143576</c:v>
                </c:pt>
                <c:pt idx="186">
                  <c:v>0.352338504988525</c:v>
                </c:pt>
                <c:pt idx="187">
                  <c:v>0.353042680704435</c:v>
                </c:pt>
                <c:pt idx="188">
                  <c:v>0.352764479338179</c:v>
                </c:pt>
                <c:pt idx="189">
                  <c:v>0.3534751560986</c:v>
                </c:pt>
                <c:pt idx="190">
                  <c:v>0.351416708695321</c:v>
                </c:pt>
                <c:pt idx="191">
                  <c:v>0.352109397654199</c:v>
                </c:pt>
                <c:pt idx="192">
                  <c:v>0.35186023580793</c:v>
                </c:pt>
                <c:pt idx="193">
                  <c:v>0.352078049742752</c:v>
                </c:pt>
                <c:pt idx="194">
                  <c:v>0.35120489666684</c:v>
                </c:pt>
                <c:pt idx="195">
                  <c:v>0.351491222116209</c:v>
                </c:pt>
                <c:pt idx="196">
                  <c:v>0.351846669687359</c:v>
                </c:pt>
                <c:pt idx="197">
                  <c:v>0.351614410181461</c:v>
                </c:pt>
                <c:pt idx="198">
                  <c:v>0.351165030030151</c:v>
                </c:pt>
                <c:pt idx="199">
                  <c:v>0.351975384502888</c:v>
                </c:pt>
                <c:pt idx="200">
                  <c:v>0.35157908301937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44048968"/>
        <c:axId val="-2143819272"/>
      </c:lineChart>
      <c:catAx>
        <c:axId val="-21440489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algn="ctr">
                  <a:defRPr lang="en-US"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Time (sec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-2143819272"/>
        <c:crosses val="autoZero"/>
        <c:auto val="1"/>
        <c:lblAlgn val="ctr"/>
        <c:lblOffset val="100"/>
        <c:tickLblSkip val="20"/>
        <c:tickMarkSkip val="10"/>
        <c:noMultiLvlLbl val="0"/>
      </c:catAx>
      <c:valAx>
        <c:axId val="-2143819272"/>
        <c:scaling>
          <c:orientation val="minMax"/>
          <c:max val="0.38"/>
          <c:min val="0.32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lang="en-US"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 i="0" u="none" strike="noStrike" kern="120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Fluorescence ratio </a:t>
                </a:r>
                <a:endParaRPr lang="en-US" sz="800" b="1" i="0" u="none" strike="noStrike" kern="1200" baseline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lang="en-US"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 i="0" u="none" strike="noStrike" kern="1200" baseline="0" dirty="0" smtClean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F340</a:t>
                </a:r>
                <a:r>
                  <a:rPr lang="en-US" sz="800" b="1" i="0" u="none" strike="noStrike" kern="120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/F380)</a:t>
                </a: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lang="en-US"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 sz="800" b="1" i="0" u="none" strike="noStrike" kern="120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96301598955784"/>
              <c:y val="0.1443332517044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-21440489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82481944444444"/>
          <c:y val="0.0970138888888889"/>
          <c:w val="0.499879166666667"/>
          <c:h val="0.80597222222222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correction!$G$3</c:f>
                <c:numCache>
                  <c:formatCode>General</c:formatCode>
                  <c:ptCount val="1"/>
                  <c:pt idx="0">
                    <c:v>0.00898666570938212</c:v>
                  </c:pt>
                </c:numCache>
              </c:numRef>
            </c:plus>
            <c:minus>
              <c:numRef>
                <c:f>correction!$G$3</c:f>
                <c:numCache>
                  <c:formatCode>General</c:formatCode>
                  <c:ptCount val="1"/>
                  <c:pt idx="0">
                    <c:v>0.00898666570938212</c:v>
                  </c:pt>
                </c:numCache>
              </c:numRef>
            </c:minus>
          </c:errBars>
          <c:val>
            <c:numRef>
              <c:f>correction!$E$3</c:f>
              <c:numCache>
                <c:formatCode>General</c:formatCode>
                <c:ptCount val="1"/>
                <c:pt idx="0">
                  <c:v>0.381545599740521</c:v>
                </c:pt>
              </c:numCache>
            </c:numRef>
          </c:val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</c:spPr>
          <c:invertIfNegative val="0"/>
          <c:dPt>
            <c:idx val="0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correction!$G$4</c:f>
                <c:numCache>
                  <c:formatCode>General</c:formatCode>
                  <c:ptCount val="1"/>
                  <c:pt idx="0">
                    <c:v>0.013064777714593</c:v>
                  </c:pt>
                </c:numCache>
              </c:numRef>
            </c:plus>
            <c:minus>
              <c:numRef>
                <c:f>correction!$G$5</c:f>
                <c:numCache>
                  <c:formatCode>General</c:formatCode>
                  <c:ptCount val="1"/>
                  <c:pt idx="0">
                    <c:v>0.00948464043562819</c:v>
                  </c:pt>
                </c:numCache>
              </c:numRef>
            </c:minus>
          </c:errBars>
          <c:val>
            <c:numRef>
              <c:f>correction!$E$4</c:f>
              <c:numCache>
                <c:formatCode>General</c:formatCode>
                <c:ptCount val="1"/>
                <c:pt idx="0">
                  <c:v>0.355660591332763</c:v>
                </c:pt>
              </c:numCache>
            </c:numRef>
          </c:val>
        </c:ser>
        <c:ser>
          <c:idx val="2"/>
          <c:order val="2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correction!$G$5</c:f>
                <c:numCache>
                  <c:formatCode>General</c:formatCode>
                  <c:ptCount val="1"/>
                  <c:pt idx="0">
                    <c:v>0.00948464043562819</c:v>
                  </c:pt>
                </c:numCache>
              </c:numRef>
            </c:plus>
            <c:minus>
              <c:numRef>
                <c:f>correction!$G$5</c:f>
                <c:numCache>
                  <c:formatCode>General</c:formatCode>
                  <c:ptCount val="1"/>
                  <c:pt idx="0">
                    <c:v>0.00948464043562819</c:v>
                  </c:pt>
                </c:numCache>
              </c:numRef>
            </c:minus>
          </c:errBars>
          <c:val>
            <c:numRef>
              <c:f>correction!$E$5</c:f>
              <c:numCache>
                <c:formatCode>General</c:formatCode>
                <c:ptCount val="1"/>
                <c:pt idx="0">
                  <c:v>0.358383055844025</c:v>
                </c:pt>
              </c:numCache>
            </c:numRef>
          </c:val>
        </c:ser>
        <c:ser>
          <c:idx val="3"/>
          <c:order val="3"/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correction!$G$6</c:f>
                <c:numCache>
                  <c:formatCode>General</c:formatCode>
                  <c:ptCount val="1"/>
                  <c:pt idx="0">
                    <c:v>0.0105751608159792</c:v>
                  </c:pt>
                </c:numCache>
              </c:numRef>
            </c:plus>
            <c:minus>
              <c:numRef>
                <c:f>correction!$G$6</c:f>
                <c:numCache>
                  <c:formatCode>General</c:formatCode>
                  <c:ptCount val="1"/>
                  <c:pt idx="0">
                    <c:v>0.0105751608159792</c:v>
                  </c:pt>
                </c:numCache>
              </c:numRef>
            </c:minus>
          </c:errBars>
          <c:val>
            <c:numRef>
              <c:f>correction!$E$6</c:f>
              <c:numCache>
                <c:formatCode>General</c:formatCode>
                <c:ptCount val="1"/>
                <c:pt idx="0">
                  <c:v>0.3783333826648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4023608"/>
        <c:axId val="-2144052808"/>
      </c:barChart>
      <c:catAx>
        <c:axId val="-214402360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2700">
            <a:solidFill>
              <a:schemeClr val="tx1"/>
            </a:solidFill>
          </a:ln>
        </c:spPr>
        <c:crossAx val="-2144052808"/>
        <c:crosses val="autoZero"/>
        <c:auto val="1"/>
        <c:lblAlgn val="ctr"/>
        <c:lblOffset val="100"/>
        <c:noMultiLvlLbl val="0"/>
      </c:catAx>
      <c:valAx>
        <c:axId val="-2144052808"/>
        <c:scaling>
          <c:orientation val="minMax"/>
          <c:max val="0.45"/>
          <c:min val="0.2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 algn="ctr">
                  <a:defRPr lang="en-US"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1" i="0" u="none" strike="noStrike" kern="120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Fluorescence ratio (F340/F380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-2144023608"/>
        <c:crosses val="autoZero"/>
        <c:crossBetween val="between"/>
        <c:majorUnit val="0.05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correction!$G$9</c:f>
                <c:numCache>
                  <c:formatCode>General</c:formatCode>
                  <c:ptCount val="1"/>
                  <c:pt idx="0">
                    <c:v>0.00970778704695766</c:v>
                  </c:pt>
                </c:numCache>
              </c:numRef>
            </c:plus>
            <c:minus>
              <c:numRef>
                <c:f>correction!$G$9</c:f>
                <c:numCache>
                  <c:formatCode>General</c:formatCode>
                  <c:ptCount val="1"/>
                  <c:pt idx="0">
                    <c:v>0.00970778704695766</c:v>
                  </c:pt>
                </c:numCache>
              </c:numRef>
            </c:minus>
          </c:errBars>
          <c:val>
            <c:numRef>
              <c:f>correction!$E$9</c:f>
              <c:numCache>
                <c:formatCode>General</c:formatCode>
                <c:ptCount val="1"/>
                <c:pt idx="0">
                  <c:v>0.186075046824719</c:v>
                </c:pt>
              </c:numCache>
            </c:numRef>
          </c:val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correction!$G$10</c:f>
                <c:numCache>
                  <c:formatCode>General</c:formatCode>
                  <c:ptCount val="1"/>
                  <c:pt idx="0">
                    <c:v>0.0173899649900229</c:v>
                  </c:pt>
                </c:numCache>
              </c:numRef>
            </c:plus>
            <c:minus>
              <c:numRef>
                <c:f>correction!$G$10</c:f>
                <c:numCache>
                  <c:formatCode>General</c:formatCode>
                  <c:ptCount val="1"/>
                  <c:pt idx="0">
                    <c:v>0.0173899649900229</c:v>
                  </c:pt>
                </c:numCache>
              </c:numRef>
            </c:minus>
          </c:errBars>
          <c:val>
            <c:numRef>
              <c:f>correction!$E$10</c:f>
              <c:numCache>
                <c:formatCode>General</c:formatCode>
                <c:ptCount val="1"/>
                <c:pt idx="0">
                  <c:v>0.130319479951143</c:v>
                </c:pt>
              </c:numCache>
            </c:numRef>
          </c:val>
        </c:ser>
        <c:ser>
          <c:idx val="2"/>
          <c:order val="2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correction!$G$11</c:f>
                <c:numCache>
                  <c:formatCode>General</c:formatCode>
                  <c:ptCount val="1"/>
                  <c:pt idx="0">
                    <c:v>0.0126212823614863</c:v>
                  </c:pt>
                </c:numCache>
              </c:numRef>
            </c:plus>
            <c:minus>
              <c:numRef>
                <c:f>correction!$G$11</c:f>
                <c:numCache>
                  <c:formatCode>General</c:formatCode>
                  <c:ptCount val="1"/>
                  <c:pt idx="0">
                    <c:v>0.0126212823614863</c:v>
                  </c:pt>
                </c:numCache>
              </c:numRef>
            </c:minus>
          </c:errBars>
          <c:val>
            <c:numRef>
              <c:f>correction!$E$11</c:f>
              <c:numCache>
                <c:formatCode>General</c:formatCode>
                <c:ptCount val="1"/>
                <c:pt idx="0">
                  <c:v>0.219243291348435</c:v>
                </c:pt>
              </c:numCache>
            </c:numRef>
          </c:val>
        </c:ser>
        <c:ser>
          <c:idx val="3"/>
          <c:order val="3"/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correction!$G$12</c:f>
                <c:numCache>
                  <c:formatCode>General</c:formatCode>
                  <c:ptCount val="1"/>
                  <c:pt idx="0">
                    <c:v>0.00827503892390132</c:v>
                  </c:pt>
                </c:numCache>
              </c:numRef>
            </c:plus>
            <c:minus>
              <c:numRef>
                <c:f>correction!$G$12</c:f>
                <c:numCache>
                  <c:formatCode>General</c:formatCode>
                  <c:ptCount val="1"/>
                  <c:pt idx="0">
                    <c:v>0.00827503892390132</c:v>
                  </c:pt>
                </c:numCache>
              </c:numRef>
            </c:minus>
          </c:errBars>
          <c:val>
            <c:numRef>
              <c:f>correction!$E$12</c:f>
              <c:numCache>
                <c:formatCode>General</c:formatCode>
                <c:ptCount val="1"/>
                <c:pt idx="0">
                  <c:v>0.2370945033357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3394024"/>
        <c:axId val="-2143812504"/>
      </c:barChart>
      <c:catAx>
        <c:axId val="-214339402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2700">
            <a:solidFill>
              <a:schemeClr val="tx1"/>
            </a:solidFill>
          </a:ln>
        </c:spPr>
        <c:crossAx val="-2143812504"/>
        <c:crosses val="autoZero"/>
        <c:auto val="1"/>
        <c:lblAlgn val="ctr"/>
        <c:lblOffset val="100"/>
        <c:noMultiLvlLbl val="0"/>
      </c:catAx>
      <c:valAx>
        <c:axId val="-21438125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l-GR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fr-FR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340/F380</a:t>
                </a:r>
              </a:p>
            </c:rich>
          </c:tx>
          <c:layout/>
          <c:overlay val="0"/>
        </c:title>
        <c:numFmt formatCode="#,##0.00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-21433940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 algn="ctr">
        <a:defRPr lang="en-US" sz="1800" b="1" i="0" u="none" strike="noStrike" kern="1200" baseline="0">
          <a:solidFill>
            <a:sysClr val="windowText" lastClr="000000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fr-FR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</c:spPr>
          <c:invertIfNegative val="0"/>
          <c:dPt>
            <c:idx val="0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correction!$G$15</c:f>
                <c:numCache>
                  <c:formatCode>General</c:formatCode>
                  <c:ptCount val="1"/>
                  <c:pt idx="0">
                    <c:v>0.00377291940986471</c:v>
                  </c:pt>
                </c:numCache>
              </c:numRef>
            </c:plus>
            <c:minus>
              <c:numRef>
                <c:f>correction!$G$15</c:f>
                <c:numCache>
                  <c:formatCode>General</c:formatCode>
                  <c:ptCount val="1"/>
                  <c:pt idx="0">
                    <c:v>0.00377291940986471</c:v>
                  </c:pt>
                </c:numCache>
              </c:numRef>
            </c:minus>
          </c:errBars>
          <c:val>
            <c:numRef>
              <c:f>correction!$E$15</c:f>
              <c:numCache>
                <c:formatCode>General</c:formatCode>
                <c:ptCount val="1"/>
                <c:pt idx="0">
                  <c:v>0.0213778923795686</c:v>
                </c:pt>
              </c:numCache>
            </c:numRef>
          </c:val>
        </c:ser>
        <c:ser>
          <c:idx val="1"/>
          <c:order val="1"/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correction!$G$16</c:f>
                <c:numCache>
                  <c:formatCode>General</c:formatCode>
                  <c:ptCount val="1"/>
                  <c:pt idx="0">
                    <c:v>0.00189191043571982</c:v>
                  </c:pt>
                </c:numCache>
              </c:numRef>
            </c:plus>
            <c:minus>
              <c:numRef>
                <c:f>correction!$G$16</c:f>
                <c:numCache>
                  <c:formatCode>General</c:formatCode>
                  <c:ptCount val="1"/>
                  <c:pt idx="0">
                    <c:v>0.00189191043571982</c:v>
                  </c:pt>
                </c:numCache>
              </c:numRef>
            </c:minus>
          </c:errBars>
          <c:val>
            <c:numRef>
              <c:f>correction!$E$16</c:f>
              <c:numCache>
                <c:formatCode>General</c:formatCode>
                <c:ptCount val="1"/>
                <c:pt idx="0">
                  <c:v>0.006631203306741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3978600"/>
        <c:axId val="-2144099480"/>
      </c:barChart>
      <c:catAx>
        <c:axId val="-214397860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2700">
            <a:solidFill>
              <a:schemeClr val="tx1"/>
            </a:solidFill>
          </a:ln>
        </c:spPr>
        <c:crossAx val="-2144099480"/>
        <c:crosses val="autoZero"/>
        <c:auto val="1"/>
        <c:lblAlgn val="ctr"/>
        <c:lblOffset val="100"/>
        <c:noMultiLvlLbl val="0"/>
      </c:catAx>
      <c:valAx>
        <c:axId val="-21440994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lang="en-US" sz="8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l-GR" sz="800" b="1" i="0" u="none" strike="noStrike" kern="1200" baseline="0" dirty="0" smtClean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Δ</a:t>
                </a:r>
                <a:r>
                  <a:rPr lang="fr-FR" sz="800" b="1" i="0" u="none" strike="noStrike" kern="1200" baseline="0" dirty="0" smtClean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 </a:t>
                </a:r>
                <a:r>
                  <a:rPr lang="en-US" sz="800" b="1" i="0" u="none" strike="noStrike" kern="1200" baseline="0" dirty="0" smtClean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F340/F380</a:t>
                </a:r>
                <a:endParaRPr lang="en-US" sz="800" b="1" i="0" u="none" strike="noStrike" kern="1200" baseline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#,##0.000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algn="ctr" rtl="0">
              <a:defRPr lang="en-US"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-21439786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737</cdr:x>
      <cdr:y>0.13807</cdr:y>
    </cdr:from>
    <cdr:to>
      <cdr:x>0.94118</cdr:x>
      <cdr:y>0.13807</cdr:y>
    </cdr:to>
    <cdr:cxnSp macro="">
      <cdr:nvCxnSpPr>
        <cdr:cNvPr id="3" name="Connecteur droit 2"/>
        <cdr:cNvCxnSpPr/>
      </cdr:nvCxnSpPr>
      <cdr:spPr>
        <a:xfrm xmlns:a="http://schemas.openxmlformats.org/drawingml/2006/main" flipV="1">
          <a:off x="671005" y="196330"/>
          <a:ext cx="1636394" cy="0"/>
        </a:xfrm>
        <a:prstGeom xmlns:a="http://schemas.openxmlformats.org/drawingml/2006/main" prst="line">
          <a:avLst/>
        </a:prstGeom>
        <a:ln xmlns:a="http://schemas.openxmlformats.org/drawingml/2006/main" w="635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1264</cdr:x>
      <cdr:y>0</cdr:y>
    </cdr:from>
    <cdr:to>
      <cdr:x>0.63868</cdr:x>
      <cdr:y>0.15038</cdr:y>
    </cdr:to>
    <cdr:sp macro="" textlink="">
      <cdr:nvSpPr>
        <cdr:cNvPr id="5" name="ZoneTexte 4"/>
        <cdr:cNvSpPr txBox="1"/>
      </cdr:nvSpPr>
      <cdr:spPr>
        <a:xfrm xmlns:a="http://schemas.openxmlformats.org/drawingml/2006/main">
          <a:off x="1011627" y="-3578549"/>
          <a:ext cx="554160" cy="2138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800" b="0" i="0" u="none" strike="noStrike" kern="1200" baseline="0" dirty="0" err="1">
              <a:solidFill>
                <a:sysClr val="windowText" lastClr="000000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Thapsigargin</a:t>
          </a:r>
          <a:r>
            <a:rPr lang="en-US" sz="800" b="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800" b="0" i="0" u="none" strike="noStrike" kern="1200" baseline="0" dirty="0" smtClean="0">
              <a:solidFill>
                <a:sysClr val="windowText" lastClr="000000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1 µM</a:t>
          </a:r>
          <a:endParaRPr lang="en-US" sz="800" b="0" i="0" u="none" strike="noStrike" kern="1200" baseline="0" dirty="0">
            <a:solidFill>
              <a:sysClr val="windowText" lastClr="000000"/>
            </a:solidFill>
            <a:effectLst/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75903</cdr:x>
      <cdr:y>0.29699</cdr:y>
    </cdr:from>
    <cdr:to>
      <cdr:x>0.85731</cdr:x>
      <cdr:y>0.44736</cdr:y>
    </cdr:to>
    <cdr:sp macro="" textlink="">
      <cdr:nvSpPr>
        <cdr:cNvPr id="6" name="ZoneTexte 5"/>
        <cdr:cNvSpPr txBox="1"/>
      </cdr:nvSpPr>
      <cdr:spPr>
        <a:xfrm xmlns:a="http://schemas.openxmlformats.org/drawingml/2006/main">
          <a:off x="1860848" y="422323"/>
          <a:ext cx="240943" cy="2138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800" b="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Control</a:t>
          </a:r>
          <a:endParaRPr lang="en-US" sz="8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6865</cdr:x>
      <cdr:y>0.51589</cdr:y>
    </cdr:from>
    <cdr:to>
      <cdr:x>0.56693</cdr:x>
      <cdr:y>0.66626</cdr:y>
    </cdr:to>
    <cdr:sp macro="" textlink="">
      <cdr:nvSpPr>
        <cdr:cNvPr id="7" name="ZoneTexte 1"/>
        <cdr:cNvSpPr txBox="1"/>
      </cdr:nvSpPr>
      <cdr:spPr>
        <a:xfrm xmlns:a="http://schemas.openxmlformats.org/drawingml/2006/main">
          <a:off x="1148946" y="733597"/>
          <a:ext cx="240943" cy="2138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 err="1">
              <a:solidFill>
                <a:schemeClr val="bg1">
                  <a:lumMod val="50000"/>
                </a:schemeClr>
              </a:solidFill>
            </a:rPr>
            <a:t>Anisomycin</a:t>
          </a:r>
          <a:r>
            <a:rPr lang="en-US" sz="800" dirty="0">
              <a:solidFill>
                <a:schemeClr val="bg1">
                  <a:lumMod val="50000"/>
                </a:schemeClr>
              </a:solidFill>
            </a:rPr>
            <a:t> pretreatment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5687</cdr:x>
      <cdr:y>0.17473</cdr:y>
    </cdr:from>
    <cdr:to>
      <cdr:x>0.96716</cdr:x>
      <cdr:y>0.17473</cdr:y>
    </cdr:to>
    <cdr:cxnSp macro="">
      <cdr:nvCxnSpPr>
        <cdr:cNvPr id="2" name="Connecteur droit 1"/>
        <cdr:cNvCxnSpPr/>
      </cdr:nvCxnSpPr>
      <cdr:spPr>
        <a:xfrm xmlns:a="http://schemas.openxmlformats.org/drawingml/2006/main">
          <a:off x="874903" y="248470"/>
          <a:ext cx="1496187" cy="0"/>
        </a:xfrm>
        <a:prstGeom xmlns:a="http://schemas.openxmlformats.org/drawingml/2006/main" prst="line">
          <a:avLst/>
        </a:prstGeom>
        <a:ln xmlns:a="http://schemas.openxmlformats.org/drawingml/2006/main" w="635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3436</cdr:x>
      <cdr:y>0.05497</cdr:y>
    </cdr:from>
    <cdr:to>
      <cdr:x>0.6604</cdr:x>
      <cdr:y>0.20535</cdr:y>
    </cdr:to>
    <cdr:sp macro="" textlink="">
      <cdr:nvSpPr>
        <cdr:cNvPr id="5" name="ZoneTexte 1"/>
        <cdr:cNvSpPr txBox="1"/>
      </cdr:nvSpPr>
      <cdr:spPr>
        <a:xfrm xmlns:a="http://schemas.openxmlformats.org/drawingml/2006/main">
          <a:off x="1064865" y="78166"/>
          <a:ext cx="554160" cy="2138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b="0" i="0" u="none" strike="noStrike" kern="1200" baseline="0" dirty="0">
              <a:solidFill>
                <a:sysClr val="windowText" lastClr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Puromycin</a:t>
          </a:r>
          <a:r>
            <a:rPr lang="en-US" sz="800" b="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800" b="0" i="0" u="none" strike="noStrike" kern="1200" baseline="0" dirty="0">
              <a:solidFill>
                <a:sysClr val="windowText" lastClr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200 </a:t>
          </a:r>
          <a:r>
            <a:rPr lang="en-US" sz="800" b="0" i="0" u="none" strike="noStrike" kern="1200" baseline="0" dirty="0" smtClean="0">
              <a:solidFill>
                <a:sysClr val="windowText" lastClr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rPr>
            <a:t>µM</a:t>
          </a:r>
          <a:endParaRPr lang="en-US" sz="800" b="0" i="0" u="none" strike="noStrike" kern="1200" baseline="0" dirty="0">
            <a:solidFill>
              <a:sysClr val="windowText" lastClr="000000"/>
            </a:solidFill>
            <a:effectLst/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76284</cdr:x>
      <cdr:y>0.17521</cdr:y>
    </cdr:from>
    <cdr:to>
      <cdr:x>0.86112</cdr:x>
      <cdr:y>0.32559</cdr:y>
    </cdr:to>
    <cdr:sp macro="" textlink="">
      <cdr:nvSpPr>
        <cdr:cNvPr id="6" name="ZoneTexte 1"/>
        <cdr:cNvSpPr txBox="1"/>
      </cdr:nvSpPr>
      <cdr:spPr>
        <a:xfrm xmlns:a="http://schemas.openxmlformats.org/drawingml/2006/main">
          <a:off x="1870175" y="249155"/>
          <a:ext cx="240943" cy="2138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b="0" dirty="0">
              <a:latin typeface="Times New Roman" panose="02020603050405020304" pitchFamily="18" charset="0"/>
              <a:cs typeface="Times New Roman" panose="02020603050405020304" pitchFamily="18" charset="0"/>
            </a:rPr>
            <a:t>Control</a:t>
          </a:r>
        </a:p>
      </cdr:txBody>
    </cdr:sp>
  </cdr:relSizeAnchor>
  <cdr:relSizeAnchor xmlns:cdr="http://schemas.openxmlformats.org/drawingml/2006/chartDrawing">
    <cdr:from>
      <cdr:x>0.48459</cdr:x>
      <cdr:y>0.42187</cdr:y>
    </cdr:from>
    <cdr:to>
      <cdr:x>0.58287</cdr:x>
      <cdr:y>0.57224</cdr:y>
    </cdr:to>
    <cdr:sp macro="" textlink="">
      <cdr:nvSpPr>
        <cdr:cNvPr id="7" name="ZoneTexte 1"/>
        <cdr:cNvSpPr txBox="1"/>
      </cdr:nvSpPr>
      <cdr:spPr>
        <a:xfrm xmlns:a="http://schemas.openxmlformats.org/drawingml/2006/main">
          <a:off x="1188015" y="599903"/>
          <a:ext cx="240944" cy="2138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b="0" dirty="0" err="1">
              <a:solidFill>
                <a:schemeClr val="bg1">
                  <a:lumMod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nisomycin</a:t>
          </a:r>
          <a:r>
            <a:rPr lang="en-US" sz="800" b="0" dirty="0">
              <a:solidFill>
                <a:schemeClr val="bg1">
                  <a:lumMod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 pretreatment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1485</cdr:x>
      <cdr:y>0.37383</cdr:y>
    </cdr:from>
    <cdr:to>
      <cdr:x>0.61313</cdr:x>
      <cdr:y>0.5242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741382" y="538321"/>
          <a:ext cx="141523" cy="2165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05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lang="en-US" sz="105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9655</cdr:x>
      <cdr:y>0.1546</cdr:y>
    </cdr:from>
    <cdr:to>
      <cdr:x>0.68151</cdr:x>
      <cdr:y>0.33212</cdr:y>
    </cdr:to>
    <cdr:sp macro="" textlink="">
      <cdr:nvSpPr>
        <cdr:cNvPr id="3" name="ZoneTexte 1"/>
        <cdr:cNvSpPr txBox="1"/>
      </cdr:nvSpPr>
      <cdr:spPr>
        <a:xfrm xmlns:a="http://schemas.openxmlformats.org/drawingml/2006/main">
          <a:off x="859034" y="222627"/>
          <a:ext cx="122336" cy="2556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5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lang="en-US" sz="105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72237</cdr:x>
      <cdr:y>0.10457</cdr:y>
    </cdr:from>
    <cdr:to>
      <cdr:x>0.82065</cdr:x>
      <cdr:y>0.24945</cdr:y>
    </cdr:to>
    <cdr:sp macro="" textlink="">
      <cdr:nvSpPr>
        <cdr:cNvPr id="4" name="ZoneTexte 1"/>
        <cdr:cNvSpPr txBox="1"/>
      </cdr:nvSpPr>
      <cdr:spPr>
        <a:xfrm xmlns:a="http://schemas.openxmlformats.org/drawingml/2006/main">
          <a:off x="1040218" y="150579"/>
          <a:ext cx="141523" cy="20862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50" b="1" dirty="0"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63262</cdr:x>
      <cdr:y>0.54197</cdr:y>
    </cdr:from>
    <cdr:to>
      <cdr:x>0.7309</cdr:x>
      <cdr:y>0.69234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910966" y="780435"/>
          <a:ext cx="141524" cy="2165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lang="en-US" sz="12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923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689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314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4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370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362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964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351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482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894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032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4308C-3B0F-4285-8EBC-61B09CBE6662}" type="datetimeFigureOut">
              <a:rPr lang="en-US" smtClean="0"/>
              <a:t>27/08/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5077BC-FFFF-4FD2-A33A-E997B60E90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79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0418017"/>
              </p:ext>
            </p:extLst>
          </p:nvPr>
        </p:nvGraphicFramePr>
        <p:xfrm>
          <a:off x="3667622" y="1720554"/>
          <a:ext cx="2451600" cy="142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1927617"/>
              </p:ext>
            </p:extLst>
          </p:nvPr>
        </p:nvGraphicFramePr>
        <p:xfrm>
          <a:off x="1130752" y="1660493"/>
          <a:ext cx="2451600" cy="15149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1268760" y="154766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610927" y="156894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Graphiqu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0016985"/>
              </p:ext>
            </p:extLst>
          </p:nvPr>
        </p:nvGraphicFramePr>
        <p:xfrm>
          <a:off x="4435431" y="3235452"/>
          <a:ext cx="144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Graphiqu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7151887"/>
              </p:ext>
            </p:extLst>
          </p:nvPr>
        </p:nvGraphicFramePr>
        <p:xfrm>
          <a:off x="2772222" y="3235452"/>
          <a:ext cx="144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Graphiqu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2233958"/>
              </p:ext>
            </p:extLst>
          </p:nvPr>
        </p:nvGraphicFramePr>
        <p:xfrm>
          <a:off x="1108615" y="3209362"/>
          <a:ext cx="144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1" name="ZoneTexte 10"/>
          <p:cNvSpPr txBox="1"/>
          <p:nvPr/>
        </p:nvSpPr>
        <p:spPr>
          <a:xfrm>
            <a:off x="2875730" y="313731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196736" y="313731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4528536" y="313731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280064" y="4584774"/>
            <a:ext cx="227480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             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Thapsigargin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(1µM)              -      -</a:t>
            </a:r>
          </a:p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              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Puromycin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200µM)              +      +  </a:t>
            </a:r>
            <a:endParaRPr lang="fr-FR" sz="8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              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Anisomycin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200µM</a:t>
            </a:r>
            <a:r>
              <a:rPr lang="fr-FR" sz="800" smtClean="0">
                <a:latin typeface="Times New Roman" pitchFamily="18" charset="0"/>
                <a:cs typeface="Times New Roman" pitchFamily="18" charset="0"/>
              </a:rPr>
              <a:t>)            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-       + 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398288" y="4584774"/>
            <a:ext cx="733696" cy="4616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+   +   +   +           </a:t>
            </a:r>
            <a:endParaRPr lang="fr-FR" sz="8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-    +   -    +                   </a:t>
            </a:r>
          </a:p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-    </a:t>
            </a:r>
            <a:r>
              <a:rPr lang="fr-FR" sz="800" smtClean="0">
                <a:latin typeface="Times New Roman" pitchFamily="18" charset="0"/>
                <a:cs typeface="Times New Roman" pitchFamily="18" charset="0"/>
              </a:rPr>
              <a:t>-    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+   </a:t>
            </a:r>
            <a:r>
              <a:rPr lang="fr-FR" sz="800" dirty="0">
                <a:latin typeface="Times New Roman" pitchFamily="18" charset="0"/>
                <a:cs typeface="Times New Roman" pitchFamily="18" charset="0"/>
              </a:rPr>
              <a:t>+                                     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5183532" y="4584774"/>
            <a:ext cx="733696" cy="4616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+   +   +   +           </a:t>
            </a:r>
            <a:endParaRPr lang="fr-FR" sz="8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-    +   -    +                   </a:t>
            </a:r>
          </a:p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-     -   +   </a:t>
            </a:r>
            <a:r>
              <a:rPr lang="fr-FR" sz="800" dirty="0">
                <a:latin typeface="Times New Roman" pitchFamily="18" charset="0"/>
                <a:cs typeface="Times New Roman" pitchFamily="18" charset="0"/>
              </a:rPr>
              <a:t>+                                     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389558" y="293222"/>
            <a:ext cx="2895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smtClean="0">
                <a:latin typeface="Times New Roman"/>
                <a:cs typeface="Times New Roman"/>
              </a:rPr>
              <a:t>S2 </a:t>
            </a:r>
            <a:r>
              <a:rPr lang="fr-FR" sz="1200" b="1" smtClean="0">
                <a:latin typeface="Times New Roman"/>
                <a:cs typeface="Times New Roman"/>
              </a:rPr>
              <a:t>Fig.</a:t>
            </a:r>
            <a:endParaRPr lang="en-US" sz="12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303246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10</Words>
  <Application>Microsoft Macintosh PowerPoint</Application>
  <PresentationFormat>Présentation à l'écran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eo Cassel</dc:creator>
  <cp:lastModifiedBy>anne-marie madec</cp:lastModifiedBy>
  <cp:revision>11</cp:revision>
  <dcterms:created xsi:type="dcterms:W3CDTF">2014-12-10T14:40:39Z</dcterms:created>
  <dcterms:modified xsi:type="dcterms:W3CDTF">2015-08-27T16:12:01Z</dcterms:modified>
</cp:coreProperties>
</file>